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67" r:id="rId2"/>
  </p:sldIdLst>
  <p:sldSz cx="7553325" cy="9906000"/>
  <p:notesSz cx="6669088" cy="9928225"/>
  <p:defaultTextStyle>
    <a:defPPr>
      <a:defRPr lang="en-US"/>
    </a:defPPr>
    <a:lvl1pPr marL="0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25227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50456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975683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300910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26139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1951366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276594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601822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1">
          <p15:clr>
            <a:srgbClr val="A4A3A4"/>
          </p15:clr>
        </p15:guide>
        <p15:guide id="3" orient="horz" pos="3121">
          <p15:clr>
            <a:srgbClr val="A4A3A4"/>
          </p15:clr>
        </p15:guide>
        <p15:guide id="4" pos="23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000"/>
    <a:srgbClr val="FF8181"/>
    <a:srgbClr val="FF5D5D"/>
    <a:srgbClr val="FD0F0F"/>
    <a:srgbClr val="9B4AF4"/>
    <a:srgbClr val="271DEF"/>
    <a:srgbClr val="170EC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9886" autoAdjust="0"/>
  </p:normalViewPr>
  <p:slideViewPr>
    <p:cSldViewPr>
      <p:cViewPr>
        <p:scale>
          <a:sx n="140" d="100"/>
          <a:sy n="140" d="100"/>
        </p:scale>
        <p:origin x="-1680" y="1944"/>
      </p:cViewPr>
      <p:guideLst>
        <p:guide orient="horz" pos="2880"/>
        <p:guide orient="horz" pos="3121"/>
        <p:guide pos="2161"/>
        <p:guide pos="23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assiel\Desktop\WT%20Paper%20Figures\Final%20figures_2018-1-10-PLoS%20Genetics-revised\Gli1-Gli2-RT-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assiel\Desktop\WT%20Paper%20Figures\Final%20figures_2018-1-10-PLoS%20Genetics-revised\Gli1-Gli2-RT-PC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ommy\Desktop\Sox9-Gli%20luciferase\Dosage_Ptch1_Luciferase_20140520-Sox9-Gli-ATDC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HK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847352922348117"/>
          <c:y val="6.1111111111111109E-2"/>
          <c:w val="0.79152647077651883"/>
          <c:h val="0.852657480314960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li2'!$J$1</c:f>
              <c:strCache>
                <c:ptCount val="1"/>
                <c:pt idx="0">
                  <c:v>Relative Gli2 level</c:v>
                </c:pt>
              </c:strCache>
            </c:strRef>
          </c:tx>
          <c:spPr>
            <a:solidFill>
              <a:prstClr val="black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Gli2'!$K$2:$K$5</c:f>
                <c:numCache>
                  <c:formatCode>General</c:formatCode>
                  <c:ptCount val="4"/>
                  <c:pt idx="0">
                    <c:v>1.1038638347488106</c:v>
                  </c:pt>
                  <c:pt idx="1">
                    <c:v>65.026118713438322</c:v>
                  </c:pt>
                  <c:pt idx="2">
                    <c:v>1383.033498532134</c:v>
                  </c:pt>
                  <c:pt idx="3">
                    <c:v>8369.6654992148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Gli2'!$I$2:$I$5</c:f>
              <c:strCache>
                <c:ptCount val="4"/>
                <c:pt idx="0">
                  <c:v>Mock</c:v>
                </c:pt>
                <c:pt idx="1">
                  <c:v>Gli2-0.1</c:v>
                </c:pt>
                <c:pt idx="2">
                  <c:v>Gli2-0.5</c:v>
                </c:pt>
                <c:pt idx="3">
                  <c:v>Gli2-1</c:v>
                </c:pt>
              </c:strCache>
            </c:strRef>
          </c:cat>
          <c:val>
            <c:numRef>
              <c:f>'Gli2'!$J$2:$J$5</c:f>
              <c:numCache>
                <c:formatCode>General</c:formatCode>
                <c:ptCount val="4"/>
                <c:pt idx="0">
                  <c:v>1.549116506546502</c:v>
                </c:pt>
                <c:pt idx="1">
                  <c:v>167.35418041011224</c:v>
                </c:pt>
                <c:pt idx="2">
                  <c:v>4680.6452089218392</c:v>
                </c:pt>
                <c:pt idx="3">
                  <c:v>80224.3977307593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90134016"/>
        <c:axId val="66296576"/>
      </c:barChart>
      <c:catAx>
        <c:axId val="2901340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HK"/>
          </a:p>
        </c:txPr>
        <c:crossAx val="66296576"/>
        <c:crosses val="autoZero"/>
        <c:auto val="1"/>
        <c:lblAlgn val="ctr"/>
        <c:lblOffset val="100"/>
        <c:noMultiLvlLbl val="0"/>
      </c:catAx>
      <c:valAx>
        <c:axId val="66296576"/>
        <c:scaling>
          <c:logBase val="10"/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dirty="0"/>
                  <a:t>Relative </a:t>
                </a:r>
                <a:r>
                  <a:rPr lang="en-US" sz="1000" i="1" dirty="0"/>
                  <a:t>Gli2</a:t>
                </a:r>
                <a:r>
                  <a:rPr lang="en-US" sz="1000" dirty="0"/>
                  <a:t> </a:t>
                </a:r>
                <a:r>
                  <a:rPr lang="en-US" altLang="zh-CN" sz="1000" dirty="0" smtClean="0"/>
                  <a:t>expression </a:t>
                </a:r>
                <a:r>
                  <a:rPr lang="en-US" sz="1000" dirty="0" smtClean="0"/>
                  <a:t>level</a:t>
                </a:r>
                <a:endParaRPr lang="zh-CN" sz="1000" dirty="0"/>
              </a:p>
            </c:rich>
          </c:tx>
          <c:layout>
            <c:manualLayout>
              <c:xMode val="edge"/>
              <c:yMode val="edge"/>
              <c:x val="0"/>
              <c:y val="0.1225619933237959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HK"/>
          </a:p>
        </c:txPr>
        <c:crossAx val="290134016"/>
        <c:crosses val="autoZero"/>
        <c:crossBetween val="between"/>
        <c:majorUnit val="0.2"/>
        <c:dispUnits>
          <c:builtInUnit val="hundredThousands"/>
        </c:dispUnits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zh-HK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HK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473824490693456"/>
          <c:y val="5.5555555555555552E-2"/>
          <c:w val="0.7752617550930655"/>
          <c:h val="0.840799729579257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li1'!$J$1</c:f>
              <c:strCache>
                <c:ptCount val="1"/>
                <c:pt idx="0">
                  <c:v>Relative Gli1 level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Gli1'!$K$2:$K$5</c:f>
                <c:numCache>
                  <c:formatCode>General</c:formatCode>
                  <c:ptCount val="4"/>
                  <c:pt idx="0">
                    <c:v>1.0040722438701832</c:v>
                  </c:pt>
                  <c:pt idx="1">
                    <c:v>134.68819789080399</c:v>
                  </c:pt>
                  <c:pt idx="2">
                    <c:v>1154.0848027718707</c:v>
                  </c:pt>
                  <c:pt idx="3">
                    <c:v>5230.28705089853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Gli1'!$I$2:$I$5</c:f>
              <c:strCache>
                <c:ptCount val="4"/>
                <c:pt idx="0">
                  <c:v>Mock</c:v>
                </c:pt>
                <c:pt idx="1">
                  <c:v>Gli1-0.1</c:v>
                </c:pt>
                <c:pt idx="2">
                  <c:v>Gli1-0.5</c:v>
                </c:pt>
                <c:pt idx="3">
                  <c:v>Gli1-1</c:v>
                </c:pt>
              </c:strCache>
            </c:strRef>
          </c:cat>
          <c:val>
            <c:numRef>
              <c:f>'Gli1'!$J$2:$J$5</c:f>
              <c:numCache>
                <c:formatCode>General</c:formatCode>
                <c:ptCount val="4"/>
                <c:pt idx="0">
                  <c:v>2.0064210426796976</c:v>
                </c:pt>
                <c:pt idx="1">
                  <c:v>315.73057886281771</c:v>
                </c:pt>
                <c:pt idx="2">
                  <c:v>3651.6121592538711</c:v>
                </c:pt>
                <c:pt idx="3">
                  <c:v>40088.0308811067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1"/>
        <c:axId val="290134528"/>
        <c:axId val="66299584"/>
      </c:barChart>
      <c:catAx>
        <c:axId val="2901345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HK"/>
          </a:p>
        </c:txPr>
        <c:crossAx val="66299584"/>
        <c:crosses val="autoZero"/>
        <c:auto val="1"/>
        <c:lblAlgn val="ctr"/>
        <c:lblOffset val="100"/>
        <c:noMultiLvlLbl val="0"/>
      </c:catAx>
      <c:valAx>
        <c:axId val="66299584"/>
        <c:scaling>
          <c:logBase val="10"/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dirty="0"/>
                  <a:t>Relative </a:t>
                </a:r>
                <a:r>
                  <a:rPr lang="en-US" sz="1000" i="1" dirty="0"/>
                  <a:t>Gli1</a:t>
                </a:r>
                <a:r>
                  <a:rPr lang="en-US" sz="1000" dirty="0"/>
                  <a:t> </a:t>
                </a:r>
                <a:r>
                  <a:rPr lang="en-US" altLang="zh-CN" sz="1000" dirty="0" smtClean="0"/>
                  <a:t>expression </a:t>
                </a:r>
                <a:r>
                  <a:rPr lang="en-US" sz="1000" dirty="0" smtClean="0"/>
                  <a:t>level</a:t>
                </a:r>
                <a:endParaRPr lang="zh-CN" sz="1000" dirty="0"/>
              </a:p>
            </c:rich>
          </c:tx>
          <c:layout>
            <c:manualLayout>
              <c:xMode val="edge"/>
              <c:yMode val="edge"/>
              <c:x val="4.0650419515530223E-3"/>
              <c:y val="8.8676131392666835E-2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 b="1">
                <a:latin typeface="Arial" pitchFamily="34" charset="0"/>
                <a:cs typeface="Arial" pitchFamily="34" charset="0"/>
              </a:defRPr>
            </a:pPr>
            <a:endParaRPr lang="zh-HK"/>
          </a:p>
        </c:txPr>
        <c:crossAx val="290134528"/>
        <c:crosses val="autoZero"/>
        <c:crossBetween val="between"/>
        <c:majorUnit val="0.1"/>
        <c:dispUnits>
          <c:builtInUnit val="hundredThousands"/>
        </c:dispUnits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zh-HK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HK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7554010195421064E-2"/>
          <c:y val="2.2485166297574456E-2"/>
          <c:w val="0.94244598980457894"/>
          <c:h val="0.862323188449448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li1'!$E$21</c:f>
              <c:strCache>
                <c:ptCount val="1"/>
                <c:pt idx="0">
                  <c:v>Normalized activities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Gli1'!$F$22:$F$25</c:f>
                <c:numCache>
                  <c:formatCode>General</c:formatCode>
                  <c:ptCount val="4"/>
                  <c:pt idx="0">
                    <c:v>0.10587300242398917</c:v>
                  </c:pt>
                  <c:pt idx="1">
                    <c:v>0.99803337759245359</c:v>
                  </c:pt>
                  <c:pt idx="2">
                    <c:v>0.47600295022793898</c:v>
                  </c:pt>
                  <c:pt idx="3">
                    <c:v>0.551659278300924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>
                <a:solidFill>
                  <a:schemeClr val="tx1"/>
                </a:solidFill>
              </a:ln>
            </c:spPr>
          </c:errBars>
          <c:cat>
            <c:strRef>
              <c:f>'Gli1'!$D$22:$D$25</c:f>
              <c:strCache>
                <c:ptCount val="4"/>
                <c:pt idx="0">
                  <c:v>Mock</c:v>
                </c:pt>
                <c:pt idx="1">
                  <c:v>Gli1 (0.1µg)</c:v>
                </c:pt>
                <c:pt idx="2">
                  <c:v>Gli1 (0.5µg)</c:v>
                </c:pt>
                <c:pt idx="3">
                  <c:v>Gli1 (1µg)</c:v>
                </c:pt>
              </c:strCache>
            </c:strRef>
          </c:cat>
          <c:val>
            <c:numRef>
              <c:f>'Gli1'!$E$22:$E$25</c:f>
              <c:numCache>
                <c:formatCode>General</c:formatCode>
                <c:ptCount val="4"/>
                <c:pt idx="0">
                  <c:v>1</c:v>
                </c:pt>
                <c:pt idx="1">
                  <c:v>3.5606272912722212</c:v>
                </c:pt>
                <c:pt idx="2">
                  <c:v>6.3963366871091702</c:v>
                </c:pt>
                <c:pt idx="3">
                  <c:v>6.62700631571791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90135552"/>
        <c:axId val="66301312"/>
      </c:barChart>
      <c:catAx>
        <c:axId val="29013555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HK"/>
          </a:p>
        </c:txPr>
        <c:crossAx val="66301312"/>
        <c:crosses val="autoZero"/>
        <c:auto val="1"/>
        <c:lblAlgn val="ctr"/>
        <c:lblOffset val="100"/>
        <c:noMultiLvlLbl val="0"/>
      </c:catAx>
      <c:valAx>
        <c:axId val="663013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 b="0">
                <a:latin typeface="Arial" pitchFamily="34" charset="0"/>
                <a:cs typeface="Arial" pitchFamily="34" charset="0"/>
              </a:defRPr>
            </a:pPr>
            <a:endParaRPr lang="zh-HK"/>
          </a:p>
        </c:txPr>
        <c:crossAx val="290135552"/>
        <c:crosses val="autoZero"/>
        <c:crossBetween val="between"/>
        <c:majorUnit val="2"/>
      </c:valAx>
    </c:plotArea>
    <c:plotVisOnly val="1"/>
    <c:dispBlanksAs val="gap"/>
    <c:showDLblsOverMax val="0"/>
  </c:chart>
  <c:spPr>
    <a:ln w="25400"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4CEBB1-04A4-4540-9C18-7266DF00DECA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16113" y="744538"/>
            <a:ext cx="283686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715907"/>
            <a:ext cx="5335270" cy="44677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430091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17F39E-6043-45EB-B098-0721341DF52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975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1pPr>
    <a:lvl2pPr marL="325227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2pPr>
    <a:lvl3pPr marL="650456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3pPr>
    <a:lvl4pPr marL="975683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4pPr>
    <a:lvl5pPr marL="1300910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5pPr>
    <a:lvl6pPr marL="1626139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6pPr>
    <a:lvl7pPr marL="1951366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7pPr>
    <a:lvl8pPr marL="2276594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8pPr>
    <a:lvl9pPr marL="2601822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916113" y="744538"/>
            <a:ext cx="2836862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zh-HK" sz="800" kern="1200" dirty="0" smtClean="0">
              <a:solidFill>
                <a:schemeClr val="tx1"/>
              </a:solidFill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17F39E-6043-45EB-B098-0721341DF524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6922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500" y="3077287"/>
            <a:ext cx="6420327" cy="2123369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3000" y="5613404"/>
            <a:ext cx="5287327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646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293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939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586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232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879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525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7172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76161" y="396701"/>
            <a:ext cx="1699499" cy="8452202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7667" y="396701"/>
            <a:ext cx="4972605" cy="8452202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6661" y="6365522"/>
            <a:ext cx="6420327" cy="1967442"/>
          </a:xfrm>
        </p:spPr>
        <p:txBody>
          <a:bodyPr anchor="t"/>
          <a:lstStyle>
            <a:lvl1pPr algn="l">
              <a:defRPr sz="41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6661" y="4198587"/>
            <a:ext cx="6420327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64651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29303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3939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5860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32325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8790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5255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71721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7667" y="2311402"/>
            <a:ext cx="3336051" cy="6537502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0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39607" y="2311402"/>
            <a:ext cx="3336051" cy="6537502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0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669" y="2217389"/>
            <a:ext cx="3337363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64651" indent="0">
              <a:buNone/>
              <a:defRPr sz="2000" b="1"/>
            </a:lvl2pPr>
            <a:lvl3pPr marL="929303" indent="0">
              <a:buNone/>
              <a:defRPr sz="1900" b="1"/>
            </a:lvl3pPr>
            <a:lvl4pPr marL="1393954" indent="0">
              <a:buNone/>
              <a:defRPr sz="1700" b="1"/>
            </a:lvl4pPr>
            <a:lvl5pPr marL="1858605" indent="0">
              <a:buNone/>
              <a:defRPr sz="1700" b="1"/>
            </a:lvl5pPr>
            <a:lvl6pPr marL="2323256" indent="0">
              <a:buNone/>
              <a:defRPr sz="1700" b="1"/>
            </a:lvl6pPr>
            <a:lvl7pPr marL="2787907" indent="0">
              <a:buNone/>
              <a:defRPr sz="1700" b="1"/>
            </a:lvl7pPr>
            <a:lvl8pPr marL="3252558" indent="0">
              <a:buNone/>
              <a:defRPr sz="1700" b="1"/>
            </a:lvl8pPr>
            <a:lvl9pPr marL="3717210" indent="0">
              <a:buNone/>
              <a:defRPr sz="17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669" y="3141486"/>
            <a:ext cx="3337363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36987" y="2217389"/>
            <a:ext cx="3338674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64651" indent="0">
              <a:buNone/>
              <a:defRPr sz="2000" b="1"/>
            </a:lvl2pPr>
            <a:lvl3pPr marL="929303" indent="0">
              <a:buNone/>
              <a:defRPr sz="1900" b="1"/>
            </a:lvl3pPr>
            <a:lvl4pPr marL="1393954" indent="0">
              <a:buNone/>
              <a:defRPr sz="1700" b="1"/>
            </a:lvl4pPr>
            <a:lvl5pPr marL="1858605" indent="0">
              <a:buNone/>
              <a:defRPr sz="1700" b="1"/>
            </a:lvl5pPr>
            <a:lvl6pPr marL="2323256" indent="0">
              <a:buNone/>
              <a:defRPr sz="1700" b="1"/>
            </a:lvl6pPr>
            <a:lvl7pPr marL="2787907" indent="0">
              <a:buNone/>
              <a:defRPr sz="1700" b="1"/>
            </a:lvl7pPr>
            <a:lvl8pPr marL="3252558" indent="0">
              <a:buNone/>
              <a:defRPr sz="1700" b="1"/>
            </a:lvl8pPr>
            <a:lvl9pPr marL="3717210" indent="0">
              <a:buNone/>
              <a:defRPr sz="17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36987" y="3141486"/>
            <a:ext cx="3338674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7670" y="394409"/>
            <a:ext cx="2484992" cy="167851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3143" y="394410"/>
            <a:ext cx="4222519" cy="8454497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7670" y="2072922"/>
            <a:ext cx="2484992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64651" indent="0">
              <a:buNone/>
              <a:defRPr sz="1200"/>
            </a:lvl2pPr>
            <a:lvl3pPr marL="929303" indent="0">
              <a:buNone/>
              <a:defRPr sz="1000"/>
            </a:lvl3pPr>
            <a:lvl4pPr marL="1393954" indent="0">
              <a:buNone/>
              <a:defRPr sz="900"/>
            </a:lvl4pPr>
            <a:lvl5pPr marL="1858605" indent="0">
              <a:buNone/>
              <a:defRPr sz="900"/>
            </a:lvl5pPr>
            <a:lvl6pPr marL="2323256" indent="0">
              <a:buNone/>
              <a:defRPr sz="900"/>
            </a:lvl6pPr>
            <a:lvl7pPr marL="2787907" indent="0">
              <a:buNone/>
              <a:defRPr sz="900"/>
            </a:lvl7pPr>
            <a:lvl8pPr marL="3252558" indent="0">
              <a:buNone/>
              <a:defRPr sz="900"/>
            </a:lvl8pPr>
            <a:lvl9pPr marL="371721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0506" y="6934201"/>
            <a:ext cx="4531995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0506" y="885119"/>
            <a:ext cx="4531995" cy="5943600"/>
          </a:xfrm>
        </p:spPr>
        <p:txBody>
          <a:bodyPr/>
          <a:lstStyle>
            <a:lvl1pPr marL="0" indent="0">
              <a:buNone/>
              <a:defRPr sz="3300"/>
            </a:lvl1pPr>
            <a:lvl2pPr marL="464651" indent="0">
              <a:buNone/>
              <a:defRPr sz="2900"/>
            </a:lvl2pPr>
            <a:lvl3pPr marL="929303" indent="0">
              <a:buNone/>
              <a:defRPr sz="2400"/>
            </a:lvl3pPr>
            <a:lvl4pPr marL="1393954" indent="0">
              <a:buNone/>
              <a:defRPr sz="2000"/>
            </a:lvl4pPr>
            <a:lvl5pPr marL="1858605" indent="0">
              <a:buNone/>
              <a:defRPr sz="2000"/>
            </a:lvl5pPr>
            <a:lvl6pPr marL="2323256" indent="0">
              <a:buNone/>
              <a:defRPr sz="2000"/>
            </a:lvl6pPr>
            <a:lvl7pPr marL="2787907" indent="0">
              <a:buNone/>
              <a:defRPr sz="2000"/>
            </a:lvl7pPr>
            <a:lvl8pPr marL="3252558" indent="0">
              <a:buNone/>
              <a:defRPr sz="2000"/>
            </a:lvl8pPr>
            <a:lvl9pPr marL="371721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0506" y="7752824"/>
            <a:ext cx="4531995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64651" indent="0">
              <a:buNone/>
              <a:defRPr sz="1200"/>
            </a:lvl2pPr>
            <a:lvl3pPr marL="929303" indent="0">
              <a:buNone/>
              <a:defRPr sz="1000"/>
            </a:lvl3pPr>
            <a:lvl4pPr marL="1393954" indent="0">
              <a:buNone/>
              <a:defRPr sz="900"/>
            </a:lvl4pPr>
            <a:lvl5pPr marL="1858605" indent="0">
              <a:buNone/>
              <a:defRPr sz="900"/>
            </a:lvl5pPr>
            <a:lvl6pPr marL="2323256" indent="0">
              <a:buNone/>
              <a:defRPr sz="900"/>
            </a:lvl6pPr>
            <a:lvl7pPr marL="2787907" indent="0">
              <a:buNone/>
              <a:defRPr sz="900"/>
            </a:lvl7pPr>
            <a:lvl8pPr marL="3252558" indent="0">
              <a:buNone/>
              <a:defRPr sz="900"/>
            </a:lvl8pPr>
            <a:lvl9pPr marL="371721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7667" y="396698"/>
            <a:ext cx="6797993" cy="1651000"/>
          </a:xfrm>
          <a:prstGeom prst="rect">
            <a:avLst/>
          </a:prstGeom>
        </p:spPr>
        <p:txBody>
          <a:bodyPr vert="horz" lIns="92930" tIns="46465" rIns="92930" bIns="46465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667" y="2311402"/>
            <a:ext cx="6797993" cy="6537502"/>
          </a:xfrm>
          <a:prstGeom prst="rect">
            <a:avLst/>
          </a:prstGeom>
        </p:spPr>
        <p:txBody>
          <a:bodyPr vert="horz" lIns="92930" tIns="46465" rIns="92930" bIns="46465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7667" y="9181396"/>
            <a:ext cx="1762442" cy="527402"/>
          </a:xfrm>
          <a:prstGeom prst="rect">
            <a:avLst/>
          </a:prstGeom>
        </p:spPr>
        <p:txBody>
          <a:bodyPr vert="horz" lIns="92930" tIns="46465" rIns="92930" bIns="46465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0720" y="9181396"/>
            <a:ext cx="2391887" cy="527402"/>
          </a:xfrm>
          <a:prstGeom prst="rect">
            <a:avLst/>
          </a:prstGeom>
        </p:spPr>
        <p:txBody>
          <a:bodyPr vert="horz" lIns="92930" tIns="46465" rIns="92930" bIns="46465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13217" y="9181396"/>
            <a:ext cx="1762442" cy="527402"/>
          </a:xfrm>
          <a:prstGeom prst="rect">
            <a:avLst/>
          </a:prstGeom>
        </p:spPr>
        <p:txBody>
          <a:bodyPr vert="horz" lIns="92930" tIns="46465" rIns="92930" bIns="46465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29303" rtl="0" eaLnBrk="1" latinLnBrk="0" hangingPunct="1">
        <a:spcBef>
          <a:spcPct val="0"/>
        </a:spcBef>
        <a:buNone/>
        <a:defRPr sz="4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8488" indent="-348488" algn="l" defTabSz="929303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1pPr>
      <a:lvl2pPr marL="755059" indent="-290407" algn="l" defTabSz="929303" rtl="0" eaLnBrk="1" latinLnBrk="0" hangingPunct="1">
        <a:spcBef>
          <a:spcPct val="20000"/>
        </a:spcBef>
        <a:buFont typeface="Arial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61628" indent="-232326" algn="l" defTabSz="929303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26280" indent="-232326" algn="l" defTabSz="929303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90930" indent="-232326" algn="l" defTabSz="929303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55581" indent="-232326" algn="l" defTabSz="92930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20233" indent="-232326" algn="l" defTabSz="92930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84884" indent="-232326" algn="l" defTabSz="92930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949535" indent="-232326" algn="l" defTabSz="92930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64651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29303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393954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858605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23256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787907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252558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717210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chart" Target="../charts/chart1.xml"/><Relationship Id="rId4" Type="http://schemas.openxmlformats.org/officeDocument/2006/relationships/image" Target="../media/image2.png"/><Relationship Id="rId9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365" y="4254326"/>
            <a:ext cx="2816225" cy="639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3017" y="3469961"/>
            <a:ext cx="2816225" cy="639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56" name="Chart 1"/>
          <p:cNvGraphicFramePr/>
          <p:nvPr>
            <p:extLst>
              <p:ext uri="{D42A27DB-BD31-4B8C-83A1-F6EECF244321}">
                <p14:modId xmlns:p14="http://schemas.microsoft.com/office/powerpoint/2010/main" val="3471428459"/>
              </p:ext>
            </p:extLst>
          </p:nvPr>
        </p:nvGraphicFramePr>
        <p:xfrm>
          <a:off x="482132" y="5522393"/>
          <a:ext cx="3124200" cy="251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7" name="Group 6"/>
          <p:cNvGrpSpPr/>
          <p:nvPr/>
        </p:nvGrpSpPr>
        <p:grpSpPr>
          <a:xfrm>
            <a:off x="461186" y="653902"/>
            <a:ext cx="3266536" cy="2170112"/>
            <a:chOff x="461186" y="653902"/>
            <a:chExt cx="3266536" cy="2170112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1186" y="653902"/>
              <a:ext cx="3200400" cy="21701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1" name="Right Brace 20"/>
            <p:cNvSpPr/>
            <p:nvPr/>
          </p:nvSpPr>
          <p:spPr>
            <a:xfrm>
              <a:off x="3319462" y="685800"/>
              <a:ext cx="45719" cy="339491"/>
            </a:xfrm>
            <a:prstGeom prst="rightBrace">
              <a:avLst>
                <a:gd name="adj1" fmla="val 40476"/>
                <a:gd name="adj2" fmla="val 50000"/>
              </a:avLst>
            </a:prstGeom>
            <a:noFill/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Freeform 22"/>
            <p:cNvSpPr/>
            <p:nvPr/>
          </p:nvSpPr>
          <p:spPr>
            <a:xfrm>
              <a:off x="728662" y="990601"/>
              <a:ext cx="2743200" cy="69380"/>
            </a:xfrm>
            <a:custGeom>
              <a:avLst/>
              <a:gdLst>
                <a:gd name="connsiteX0" fmla="*/ 0 w 928632"/>
                <a:gd name="connsiteY0" fmla="*/ 0 h 128087"/>
                <a:gd name="connsiteX1" fmla="*/ 10674 w 928632"/>
                <a:gd name="connsiteY1" fmla="*/ 3558 h 128087"/>
                <a:gd name="connsiteX2" fmla="*/ 32022 w 928632"/>
                <a:gd name="connsiteY2" fmla="*/ 17790 h 128087"/>
                <a:gd name="connsiteX3" fmla="*/ 53370 w 928632"/>
                <a:gd name="connsiteY3" fmla="*/ 24906 h 128087"/>
                <a:gd name="connsiteX4" fmla="*/ 64044 w 928632"/>
                <a:gd name="connsiteY4" fmla="*/ 32022 h 128087"/>
                <a:gd name="connsiteX5" fmla="*/ 85392 w 928632"/>
                <a:gd name="connsiteY5" fmla="*/ 39138 h 128087"/>
                <a:gd name="connsiteX6" fmla="*/ 96066 w 928632"/>
                <a:gd name="connsiteY6" fmla="*/ 46253 h 128087"/>
                <a:gd name="connsiteX7" fmla="*/ 113856 w 928632"/>
                <a:gd name="connsiteY7" fmla="*/ 49811 h 128087"/>
                <a:gd name="connsiteX8" fmla="*/ 149435 w 928632"/>
                <a:gd name="connsiteY8" fmla="*/ 56927 h 128087"/>
                <a:gd name="connsiteX9" fmla="*/ 160109 w 928632"/>
                <a:gd name="connsiteY9" fmla="*/ 60485 h 128087"/>
                <a:gd name="connsiteX10" fmla="*/ 195689 w 928632"/>
                <a:gd name="connsiteY10" fmla="*/ 67601 h 128087"/>
                <a:gd name="connsiteX11" fmla="*/ 206363 w 928632"/>
                <a:gd name="connsiteY11" fmla="*/ 71159 h 128087"/>
                <a:gd name="connsiteX12" fmla="*/ 234827 w 928632"/>
                <a:gd name="connsiteY12" fmla="*/ 78275 h 128087"/>
                <a:gd name="connsiteX13" fmla="*/ 266849 w 928632"/>
                <a:gd name="connsiteY13" fmla="*/ 88949 h 128087"/>
                <a:gd name="connsiteX14" fmla="*/ 288196 w 928632"/>
                <a:gd name="connsiteY14" fmla="*/ 92507 h 128087"/>
                <a:gd name="connsiteX15" fmla="*/ 302428 w 928632"/>
                <a:gd name="connsiteY15" fmla="*/ 96065 h 128087"/>
                <a:gd name="connsiteX16" fmla="*/ 352240 w 928632"/>
                <a:gd name="connsiteY16" fmla="*/ 103181 h 128087"/>
                <a:gd name="connsiteX17" fmla="*/ 387820 w 928632"/>
                <a:gd name="connsiteY17" fmla="*/ 113855 h 128087"/>
                <a:gd name="connsiteX18" fmla="*/ 434074 w 928632"/>
                <a:gd name="connsiteY18" fmla="*/ 117413 h 128087"/>
                <a:gd name="connsiteX19" fmla="*/ 523023 w 928632"/>
                <a:gd name="connsiteY19" fmla="*/ 128087 h 128087"/>
                <a:gd name="connsiteX20" fmla="*/ 676016 w 928632"/>
                <a:gd name="connsiteY20" fmla="*/ 120971 h 128087"/>
                <a:gd name="connsiteX21" fmla="*/ 686690 w 928632"/>
                <a:gd name="connsiteY21" fmla="*/ 117413 h 128087"/>
                <a:gd name="connsiteX22" fmla="*/ 736502 w 928632"/>
                <a:gd name="connsiteY22" fmla="*/ 110297 h 128087"/>
                <a:gd name="connsiteX23" fmla="*/ 764965 w 928632"/>
                <a:gd name="connsiteY23" fmla="*/ 106739 h 128087"/>
                <a:gd name="connsiteX24" fmla="*/ 779197 w 928632"/>
                <a:gd name="connsiteY24" fmla="*/ 103181 h 128087"/>
                <a:gd name="connsiteX25" fmla="*/ 807661 w 928632"/>
                <a:gd name="connsiteY25" fmla="*/ 99623 h 128087"/>
                <a:gd name="connsiteX26" fmla="*/ 829009 w 928632"/>
                <a:gd name="connsiteY26" fmla="*/ 85391 h 128087"/>
                <a:gd name="connsiteX27" fmla="*/ 839683 w 928632"/>
                <a:gd name="connsiteY27" fmla="*/ 81833 h 128087"/>
                <a:gd name="connsiteX28" fmla="*/ 882379 w 928632"/>
                <a:gd name="connsiteY28" fmla="*/ 74717 h 128087"/>
                <a:gd name="connsiteX29" fmla="*/ 896610 w 928632"/>
                <a:gd name="connsiteY29" fmla="*/ 71159 h 128087"/>
                <a:gd name="connsiteX30" fmla="*/ 917958 w 928632"/>
                <a:gd name="connsiteY30" fmla="*/ 67601 h 128087"/>
                <a:gd name="connsiteX31" fmla="*/ 928632 w 928632"/>
                <a:gd name="connsiteY31" fmla="*/ 64043 h 1280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928632" h="128087">
                  <a:moveTo>
                    <a:pt x="0" y="0"/>
                  </a:moveTo>
                  <a:cubicBezTo>
                    <a:pt x="3558" y="1186"/>
                    <a:pt x="7396" y="1737"/>
                    <a:pt x="10674" y="3558"/>
                  </a:cubicBezTo>
                  <a:cubicBezTo>
                    <a:pt x="18150" y="7711"/>
                    <a:pt x="23909" y="15086"/>
                    <a:pt x="32022" y="17790"/>
                  </a:cubicBezTo>
                  <a:lnTo>
                    <a:pt x="53370" y="24906"/>
                  </a:lnTo>
                  <a:cubicBezTo>
                    <a:pt x="56928" y="27278"/>
                    <a:pt x="60136" y="30285"/>
                    <a:pt x="64044" y="32022"/>
                  </a:cubicBezTo>
                  <a:cubicBezTo>
                    <a:pt x="70898" y="35068"/>
                    <a:pt x="79151" y="34978"/>
                    <a:pt x="85392" y="39138"/>
                  </a:cubicBezTo>
                  <a:cubicBezTo>
                    <a:pt x="88950" y="41510"/>
                    <a:pt x="92062" y="44752"/>
                    <a:pt x="96066" y="46253"/>
                  </a:cubicBezTo>
                  <a:cubicBezTo>
                    <a:pt x="101728" y="48376"/>
                    <a:pt x="107989" y="48344"/>
                    <a:pt x="113856" y="49811"/>
                  </a:cubicBezTo>
                  <a:cubicBezTo>
                    <a:pt x="146976" y="58091"/>
                    <a:pt x="88417" y="48210"/>
                    <a:pt x="149435" y="56927"/>
                  </a:cubicBezTo>
                  <a:cubicBezTo>
                    <a:pt x="152993" y="58113"/>
                    <a:pt x="156448" y="59671"/>
                    <a:pt x="160109" y="60485"/>
                  </a:cubicBezTo>
                  <a:cubicBezTo>
                    <a:pt x="191562" y="67475"/>
                    <a:pt x="170878" y="60512"/>
                    <a:pt x="195689" y="67601"/>
                  </a:cubicBezTo>
                  <a:cubicBezTo>
                    <a:pt x="199295" y="68631"/>
                    <a:pt x="202745" y="70172"/>
                    <a:pt x="206363" y="71159"/>
                  </a:cubicBezTo>
                  <a:cubicBezTo>
                    <a:pt x="215798" y="73732"/>
                    <a:pt x="225549" y="75182"/>
                    <a:pt x="234827" y="78275"/>
                  </a:cubicBezTo>
                  <a:lnTo>
                    <a:pt x="266849" y="88949"/>
                  </a:lnTo>
                  <a:cubicBezTo>
                    <a:pt x="273693" y="91230"/>
                    <a:pt x="281122" y="91092"/>
                    <a:pt x="288196" y="92507"/>
                  </a:cubicBezTo>
                  <a:cubicBezTo>
                    <a:pt x="292991" y="93466"/>
                    <a:pt x="297605" y="95261"/>
                    <a:pt x="302428" y="96065"/>
                  </a:cubicBezTo>
                  <a:cubicBezTo>
                    <a:pt x="341782" y="102624"/>
                    <a:pt x="318645" y="96462"/>
                    <a:pt x="352240" y="103181"/>
                  </a:cubicBezTo>
                  <a:cubicBezTo>
                    <a:pt x="365683" y="105870"/>
                    <a:pt x="374205" y="109317"/>
                    <a:pt x="387820" y="113855"/>
                  </a:cubicBezTo>
                  <a:cubicBezTo>
                    <a:pt x="402490" y="118745"/>
                    <a:pt x="418656" y="116227"/>
                    <a:pt x="434074" y="117413"/>
                  </a:cubicBezTo>
                  <a:cubicBezTo>
                    <a:pt x="487136" y="128026"/>
                    <a:pt x="457585" y="123724"/>
                    <a:pt x="523023" y="128087"/>
                  </a:cubicBezTo>
                  <a:lnTo>
                    <a:pt x="676016" y="120971"/>
                  </a:lnTo>
                  <a:cubicBezTo>
                    <a:pt x="679762" y="120797"/>
                    <a:pt x="682997" y="118065"/>
                    <a:pt x="686690" y="117413"/>
                  </a:cubicBezTo>
                  <a:cubicBezTo>
                    <a:pt x="703207" y="114498"/>
                    <a:pt x="719859" y="112377"/>
                    <a:pt x="736502" y="110297"/>
                  </a:cubicBezTo>
                  <a:cubicBezTo>
                    <a:pt x="745990" y="109111"/>
                    <a:pt x="755534" y="108311"/>
                    <a:pt x="764965" y="106739"/>
                  </a:cubicBezTo>
                  <a:cubicBezTo>
                    <a:pt x="769788" y="105935"/>
                    <a:pt x="774374" y="103985"/>
                    <a:pt x="779197" y="103181"/>
                  </a:cubicBezTo>
                  <a:cubicBezTo>
                    <a:pt x="788629" y="101609"/>
                    <a:pt x="798173" y="100809"/>
                    <a:pt x="807661" y="99623"/>
                  </a:cubicBezTo>
                  <a:lnTo>
                    <a:pt x="829009" y="85391"/>
                  </a:lnTo>
                  <a:cubicBezTo>
                    <a:pt x="832130" y="83311"/>
                    <a:pt x="836077" y="82863"/>
                    <a:pt x="839683" y="81833"/>
                  </a:cubicBezTo>
                  <a:cubicBezTo>
                    <a:pt x="857967" y="76609"/>
                    <a:pt x="859278" y="77605"/>
                    <a:pt x="882379" y="74717"/>
                  </a:cubicBezTo>
                  <a:cubicBezTo>
                    <a:pt x="887123" y="73531"/>
                    <a:pt x="891815" y="72118"/>
                    <a:pt x="896610" y="71159"/>
                  </a:cubicBezTo>
                  <a:cubicBezTo>
                    <a:pt x="903684" y="69744"/>
                    <a:pt x="910916" y="69166"/>
                    <a:pt x="917958" y="67601"/>
                  </a:cubicBezTo>
                  <a:cubicBezTo>
                    <a:pt x="921619" y="66787"/>
                    <a:pt x="928632" y="64043"/>
                    <a:pt x="928632" y="64043"/>
                  </a:cubicBezTo>
                </a:path>
              </a:pathLst>
            </a:custGeom>
            <a:ln w="6350"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Freeform 23"/>
            <p:cNvSpPr/>
            <p:nvPr/>
          </p:nvSpPr>
          <p:spPr>
            <a:xfrm>
              <a:off x="543199" y="1205730"/>
              <a:ext cx="3075012" cy="242070"/>
            </a:xfrm>
            <a:custGeom>
              <a:avLst/>
              <a:gdLst>
                <a:gd name="connsiteX0" fmla="*/ 0 w 1067923"/>
                <a:gd name="connsiteY0" fmla="*/ 0 h 174620"/>
                <a:gd name="connsiteX1" fmla="*/ 32022 w 1067923"/>
                <a:gd name="connsiteY1" fmla="*/ 21348 h 174620"/>
                <a:gd name="connsiteX2" fmla="*/ 42695 w 1067923"/>
                <a:gd name="connsiteY2" fmla="*/ 28464 h 174620"/>
                <a:gd name="connsiteX3" fmla="*/ 64043 w 1067923"/>
                <a:gd name="connsiteY3" fmla="*/ 46254 h 174620"/>
                <a:gd name="connsiteX4" fmla="*/ 85391 w 1067923"/>
                <a:gd name="connsiteY4" fmla="*/ 53369 h 174620"/>
                <a:gd name="connsiteX5" fmla="*/ 96065 w 1067923"/>
                <a:gd name="connsiteY5" fmla="*/ 56927 h 174620"/>
                <a:gd name="connsiteX6" fmla="*/ 113855 w 1067923"/>
                <a:gd name="connsiteY6" fmla="*/ 74717 h 174620"/>
                <a:gd name="connsiteX7" fmla="*/ 145877 w 1067923"/>
                <a:gd name="connsiteY7" fmla="*/ 88949 h 174620"/>
                <a:gd name="connsiteX8" fmla="*/ 167225 w 1067923"/>
                <a:gd name="connsiteY8" fmla="*/ 96065 h 174620"/>
                <a:gd name="connsiteX9" fmla="*/ 177899 w 1067923"/>
                <a:gd name="connsiteY9" fmla="*/ 99623 h 174620"/>
                <a:gd name="connsiteX10" fmla="*/ 188573 w 1067923"/>
                <a:gd name="connsiteY10" fmla="*/ 106739 h 174620"/>
                <a:gd name="connsiteX11" fmla="*/ 252616 w 1067923"/>
                <a:gd name="connsiteY11" fmla="*/ 113855 h 174620"/>
                <a:gd name="connsiteX12" fmla="*/ 284638 w 1067923"/>
                <a:gd name="connsiteY12" fmla="*/ 124529 h 174620"/>
                <a:gd name="connsiteX13" fmla="*/ 320218 w 1067923"/>
                <a:gd name="connsiteY13" fmla="*/ 131645 h 174620"/>
                <a:gd name="connsiteX14" fmla="*/ 338008 w 1067923"/>
                <a:gd name="connsiteY14" fmla="*/ 135203 h 174620"/>
                <a:gd name="connsiteX15" fmla="*/ 359355 w 1067923"/>
                <a:gd name="connsiteY15" fmla="*/ 138761 h 174620"/>
                <a:gd name="connsiteX16" fmla="*/ 370029 w 1067923"/>
                <a:gd name="connsiteY16" fmla="*/ 142319 h 174620"/>
                <a:gd name="connsiteX17" fmla="*/ 405609 w 1067923"/>
                <a:gd name="connsiteY17" fmla="*/ 149435 h 174620"/>
                <a:gd name="connsiteX18" fmla="*/ 426957 w 1067923"/>
                <a:gd name="connsiteY18" fmla="*/ 156551 h 174620"/>
                <a:gd name="connsiteX19" fmla="*/ 483885 w 1067923"/>
                <a:gd name="connsiteY19" fmla="*/ 163667 h 174620"/>
                <a:gd name="connsiteX20" fmla="*/ 494559 w 1067923"/>
                <a:gd name="connsiteY20" fmla="*/ 167225 h 174620"/>
                <a:gd name="connsiteX21" fmla="*/ 597740 w 1067923"/>
                <a:gd name="connsiteY21" fmla="*/ 174341 h 174620"/>
                <a:gd name="connsiteX22" fmla="*/ 750733 w 1067923"/>
                <a:gd name="connsiteY22" fmla="*/ 170783 h 174620"/>
                <a:gd name="connsiteX23" fmla="*/ 786313 w 1067923"/>
                <a:gd name="connsiteY23" fmla="*/ 163667 h 174620"/>
                <a:gd name="connsiteX24" fmla="*/ 800545 w 1067923"/>
                <a:gd name="connsiteY24" fmla="*/ 160109 h 174620"/>
                <a:gd name="connsiteX25" fmla="*/ 811218 w 1067923"/>
                <a:gd name="connsiteY25" fmla="*/ 156551 h 174620"/>
                <a:gd name="connsiteX26" fmla="*/ 853914 w 1067923"/>
                <a:gd name="connsiteY26" fmla="*/ 149435 h 174620"/>
                <a:gd name="connsiteX27" fmla="*/ 882378 w 1067923"/>
                <a:gd name="connsiteY27" fmla="*/ 142319 h 174620"/>
                <a:gd name="connsiteX28" fmla="*/ 910842 w 1067923"/>
                <a:gd name="connsiteY28" fmla="*/ 135203 h 174620"/>
                <a:gd name="connsiteX29" fmla="*/ 921516 w 1067923"/>
                <a:gd name="connsiteY29" fmla="*/ 124529 h 174620"/>
                <a:gd name="connsiteX30" fmla="*/ 942864 w 1067923"/>
                <a:gd name="connsiteY30" fmla="*/ 117413 h 174620"/>
                <a:gd name="connsiteX31" fmla="*/ 974885 w 1067923"/>
                <a:gd name="connsiteY31" fmla="*/ 106739 h 174620"/>
                <a:gd name="connsiteX32" fmla="*/ 996233 w 1067923"/>
                <a:gd name="connsiteY32" fmla="*/ 99623 h 174620"/>
                <a:gd name="connsiteX33" fmla="*/ 1006907 w 1067923"/>
                <a:gd name="connsiteY33" fmla="*/ 96065 h 174620"/>
                <a:gd name="connsiteX34" fmla="*/ 1017581 w 1067923"/>
                <a:gd name="connsiteY34" fmla="*/ 88949 h 174620"/>
                <a:gd name="connsiteX35" fmla="*/ 1038929 w 1067923"/>
                <a:gd name="connsiteY35" fmla="*/ 81833 h 174620"/>
                <a:gd name="connsiteX36" fmla="*/ 1049603 w 1067923"/>
                <a:gd name="connsiteY36" fmla="*/ 74717 h 174620"/>
                <a:gd name="connsiteX37" fmla="*/ 1067393 w 1067923"/>
                <a:gd name="connsiteY37" fmla="*/ 60485 h 174620"/>
                <a:gd name="connsiteX38" fmla="*/ 1067393 w 1067923"/>
                <a:gd name="connsiteY38" fmla="*/ 56927 h 1746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</a:cxnLst>
              <a:rect l="l" t="t" r="r" b="b"/>
              <a:pathLst>
                <a:path w="1067923" h="174620">
                  <a:moveTo>
                    <a:pt x="0" y="0"/>
                  </a:moveTo>
                  <a:lnTo>
                    <a:pt x="32022" y="21348"/>
                  </a:lnTo>
                  <a:cubicBezTo>
                    <a:pt x="35580" y="23720"/>
                    <a:pt x="39671" y="25440"/>
                    <a:pt x="42695" y="28464"/>
                  </a:cubicBezTo>
                  <a:cubicBezTo>
                    <a:pt x="49398" y="35167"/>
                    <a:pt x="55127" y="42292"/>
                    <a:pt x="64043" y="46254"/>
                  </a:cubicBezTo>
                  <a:cubicBezTo>
                    <a:pt x="70897" y="49300"/>
                    <a:pt x="78275" y="50997"/>
                    <a:pt x="85391" y="53369"/>
                  </a:cubicBezTo>
                  <a:lnTo>
                    <a:pt x="96065" y="56927"/>
                  </a:lnTo>
                  <a:cubicBezTo>
                    <a:pt x="124529" y="75903"/>
                    <a:pt x="90135" y="50997"/>
                    <a:pt x="113855" y="74717"/>
                  </a:cubicBezTo>
                  <a:cubicBezTo>
                    <a:pt x="122313" y="83175"/>
                    <a:pt x="135308" y="85426"/>
                    <a:pt x="145877" y="88949"/>
                  </a:cubicBezTo>
                  <a:lnTo>
                    <a:pt x="167225" y="96065"/>
                  </a:lnTo>
                  <a:lnTo>
                    <a:pt x="177899" y="99623"/>
                  </a:lnTo>
                  <a:cubicBezTo>
                    <a:pt x="181457" y="101995"/>
                    <a:pt x="184447" y="105614"/>
                    <a:pt x="188573" y="106739"/>
                  </a:cubicBezTo>
                  <a:cubicBezTo>
                    <a:pt x="194405" y="108330"/>
                    <a:pt x="250476" y="113641"/>
                    <a:pt x="252616" y="113855"/>
                  </a:cubicBezTo>
                  <a:lnTo>
                    <a:pt x="284638" y="124529"/>
                  </a:lnTo>
                  <a:cubicBezTo>
                    <a:pt x="296112" y="128354"/>
                    <a:pt x="308358" y="129273"/>
                    <a:pt x="320218" y="131645"/>
                  </a:cubicBezTo>
                  <a:lnTo>
                    <a:pt x="338008" y="135203"/>
                  </a:lnTo>
                  <a:cubicBezTo>
                    <a:pt x="345082" y="136618"/>
                    <a:pt x="352313" y="137196"/>
                    <a:pt x="359355" y="138761"/>
                  </a:cubicBezTo>
                  <a:cubicBezTo>
                    <a:pt x="363016" y="139575"/>
                    <a:pt x="366375" y="141476"/>
                    <a:pt x="370029" y="142319"/>
                  </a:cubicBezTo>
                  <a:cubicBezTo>
                    <a:pt x="381814" y="145039"/>
                    <a:pt x="394135" y="145610"/>
                    <a:pt x="405609" y="149435"/>
                  </a:cubicBezTo>
                  <a:cubicBezTo>
                    <a:pt x="412725" y="151807"/>
                    <a:pt x="419514" y="155621"/>
                    <a:pt x="426957" y="156551"/>
                  </a:cubicBezTo>
                  <a:lnTo>
                    <a:pt x="483885" y="163667"/>
                  </a:lnTo>
                  <a:cubicBezTo>
                    <a:pt x="487443" y="164853"/>
                    <a:pt x="490898" y="166411"/>
                    <a:pt x="494559" y="167225"/>
                  </a:cubicBezTo>
                  <a:cubicBezTo>
                    <a:pt x="527833" y="174620"/>
                    <a:pt x="565491" y="172939"/>
                    <a:pt x="597740" y="174341"/>
                  </a:cubicBezTo>
                  <a:lnTo>
                    <a:pt x="750733" y="170783"/>
                  </a:lnTo>
                  <a:cubicBezTo>
                    <a:pt x="775445" y="169795"/>
                    <a:pt x="769430" y="168491"/>
                    <a:pt x="786313" y="163667"/>
                  </a:cubicBezTo>
                  <a:cubicBezTo>
                    <a:pt x="791015" y="162324"/>
                    <a:pt x="795843" y="161452"/>
                    <a:pt x="800545" y="160109"/>
                  </a:cubicBezTo>
                  <a:cubicBezTo>
                    <a:pt x="804151" y="159079"/>
                    <a:pt x="807580" y="157461"/>
                    <a:pt x="811218" y="156551"/>
                  </a:cubicBezTo>
                  <a:cubicBezTo>
                    <a:pt x="836673" y="150187"/>
                    <a:pt x="823796" y="155459"/>
                    <a:pt x="853914" y="149435"/>
                  </a:cubicBezTo>
                  <a:cubicBezTo>
                    <a:pt x="863504" y="147517"/>
                    <a:pt x="872890" y="144691"/>
                    <a:pt x="882378" y="142319"/>
                  </a:cubicBezTo>
                  <a:lnTo>
                    <a:pt x="910842" y="135203"/>
                  </a:lnTo>
                  <a:cubicBezTo>
                    <a:pt x="914400" y="131645"/>
                    <a:pt x="917117" y="126973"/>
                    <a:pt x="921516" y="124529"/>
                  </a:cubicBezTo>
                  <a:cubicBezTo>
                    <a:pt x="928073" y="120886"/>
                    <a:pt x="935748" y="119785"/>
                    <a:pt x="942864" y="117413"/>
                  </a:cubicBezTo>
                  <a:lnTo>
                    <a:pt x="974885" y="106739"/>
                  </a:lnTo>
                  <a:lnTo>
                    <a:pt x="996233" y="99623"/>
                  </a:lnTo>
                  <a:lnTo>
                    <a:pt x="1006907" y="96065"/>
                  </a:lnTo>
                  <a:cubicBezTo>
                    <a:pt x="1010465" y="93693"/>
                    <a:pt x="1013673" y="90686"/>
                    <a:pt x="1017581" y="88949"/>
                  </a:cubicBezTo>
                  <a:cubicBezTo>
                    <a:pt x="1024435" y="85903"/>
                    <a:pt x="1038929" y="81833"/>
                    <a:pt x="1038929" y="81833"/>
                  </a:cubicBezTo>
                  <a:cubicBezTo>
                    <a:pt x="1042487" y="79461"/>
                    <a:pt x="1045778" y="76629"/>
                    <a:pt x="1049603" y="74717"/>
                  </a:cubicBezTo>
                  <a:cubicBezTo>
                    <a:pt x="1063282" y="67878"/>
                    <a:pt x="1059396" y="76479"/>
                    <a:pt x="1067393" y="60485"/>
                  </a:cubicBezTo>
                  <a:cubicBezTo>
                    <a:pt x="1067923" y="59424"/>
                    <a:pt x="1067393" y="58113"/>
                    <a:pt x="1067393" y="56927"/>
                  </a:cubicBezTo>
                </a:path>
              </a:pathLst>
            </a:custGeom>
            <a:ln w="6350"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Freeform 24"/>
            <p:cNvSpPr/>
            <p:nvPr/>
          </p:nvSpPr>
          <p:spPr>
            <a:xfrm>
              <a:off x="541696" y="1581198"/>
              <a:ext cx="3076515" cy="476202"/>
            </a:xfrm>
            <a:custGeom>
              <a:avLst/>
              <a:gdLst>
                <a:gd name="connsiteX0" fmla="*/ 0 w 1159900"/>
                <a:gd name="connsiteY0" fmla="*/ 0 h 298894"/>
                <a:gd name="connsiteX1" fmla="*/ 10674 w 1159900"/>
                <a:gd name="connsiteY1" fmla="*/ 3558 h 298894"/>
                <a:gd name="connsiteX2" fmla="*/ 17790 w 1159900"/>
                <a:gd name="connsiteY2" fmla="*/ 14232 h 298894"/>
                <a:gd name="connsiteX3" fmla="*/ 39138 w 1159900"/>
                <a:gd name="connsiteY3" fmla="*/ 28464 h 298894"/>
                <a:gd name="connsiteX4" fmla="*/ 60485 w 1159900"/>
                <a:gd name="connsiteY4" fmla="*/ 49812 h 298894"/>
                <a:gd name="connsiteX5" fmla="*/ 74717 w 1159900"/>
                <a:gd name="connsiteY5" fmla="*/ 71160 h 298894"/>
                <a:gd name="connsiteX6" fmla="*/ 78275 w 1159900"/>
                <a:gd name="connsiteY6" fmla="*/ 81834 h 298894"/>
                <a:gd name="connsiteX7" fmla="*/ 99623 w 1159900"/>
                <a:gd name="connsiteY7" fmla="*/ 96066 h 298894"/>
                <a:gd name="connsiteX8" fmla="*/ 120971 w 1159900"/>
                <a:gd name="connsiteY8" fmla="*/ 106739 h 298894"/>
                <a:gd name="connsiteX9" fmla="*/ 142319 w 1159900"/>
                <a:gd name="connsiteY9" fmla="*/ 117413 h 298894"/>
                <a:gd name="connsiteX10" fmla="*/ 163667 w 1159900"/>
                <a:gd name="connsiteY10" fmla="*/ 128087 h 298894"/>
                <a:gd name="connsiteX11" fmla="*/ 177899 w 1159900"/>
                <a:gd name="connsiteY11" fmla="*/ 138761 h 298894"/>
                <a:gd name="connsiteX12" fmla="*/ 188573 w 1159900"/>
                <a:gd name="connsiteY12" fmla="*/ 145877 h 298894"/>
                <a:gd name="connsiteX13" fmla="*/ 209920 w 1159900"/>
                <a:gd name="connsiteY13" fmla="*/ 163667 h 298894"/>
                <a:gd name="connsiteX14" fmla="*/ 245500 w 1159900"/>
                <a:gd name="connsiteY14" fmla="*/ 177899 h 298894"/>
                <a:gd name="connsiteX15" fmla="*/ 266848 w 1159900"/>
                <a:gd name="connsiteY15" fmla="*/ 192131 h 298894"/>
                <a:gd name="connsiteX16" fmla="*/ 288196 w 1159900"/>
                <a:gd name="connsiteY16" fmla="*/ 199247 h 298894"/>
                <a:gd name="connsiteX17" fmla="*/ 334450 w 1159900"/>
                <a:gd name="connsiteY17" fmla="*/ 217037 h 298894"/>
                <a:gd name="connsiteX18" fmla="*/ 345124 w 1159900"/>
                <a:gd name="connsiteY18" fmla="*/ 224153 h 298894"/>
                <a:gd name="connsiteX19" fmla="*/ 359355 w 1159900"/>
                <a:gd name="connsiteY19" fmla="*/ 227711 h 298894"/>
                <a:gd name="connsiteX20" fmla="*/ 380703 w 1159900"/>
                <a:gd name="connsiteY20" fmla="*/ 234827 h 298894"/>
                <a:gd name="connsiteX21" fmla="*/ 391377 w 1159900"/>
                <a:gd name="connsiteY21" fmla="*/ 238385 h 298894"/>
                <a:gd name="connsiteX22" fmla="*/ 412725 w 1159900"/>
                <a:gd name="connsiteY22" fmla="*/ 252616 h 298894"/>
                <a:gd name="connsiteX23" fmla="*/ 423399 w 1159900"/>
                <a:gd name="connsiteY23" fmla="*/ 259732 h 298894"/>
                <a:gd name="connsiteX24" fmla="*/ 444747 w 1159900"/>
                <a:gd name="connsiteY24" fmla="*/ 266848 h 298894"/>
                <a:gd name="connsiteX25" fmla="*/ 455421 w 1159900"/>
                <a:gd name="connsiteY25" fmla="*/ 273964 h 298894"/>
                <a:gd name="connsiteX26" fmla="*/ 491001 w 1159900"/>
                <a:gd name="connsiteY26" fmla="*/ 281080 h 298894"/>
                <a:gd name="connsiteX27" fmla="*/ 611972 w 1159900"/>
                <a:gd name="connsiteY27" fmla="*/ 291754 h 298894"/>
                <a:gd name="connsiteX28" fmla="*/ 679573 w 1159900"/>
                <a:gd name="connsiteY28" fmla="*/ 295312 h 298894"/>
                <a:gd name="connsiteX29" fmla="*/ 757849 w 1159900"/>
                <a:gd name="connsiteY29" fmla="*/ 291754 h 298894"/>
                <a:gd name="connsiteX30" fmla="*/ 768523 w 1159900"/>
                <a:gd name="connsiteY30" fmla="*/ 288196 h 298894"/>
                <a:gd name="connsiteX31" fmla="*/ 793429 w 1159900"/>
                <a:gd name="connsiteY31" fmla="*/ 284638 h 298894"/>
                <a:gd name="connsiteX32" fmla="*/ 814776 w 1159900"/>
                <a:gd name="connsiteY32" fmla="*/ 273964 h 298894"/>
                <a:gd name="connsiteX33" fmla="*/ 839682 w 1159900"/>
                <a:gd name="connsiteY33" fmla="*/ 266848 h 298894"/>
                <a:gd name="connsiteX34" fmla="*/ 850356 w 1159900"/>
                <a:gd name="connsiteY34" fmla="*/ 263290 h 298894"/>
                <a:gd name="connsiteX35" fmla="*/ 864588 w 1159900"/>
                <a:gd name="connsiteY35" fmla="*/ 259732 h 298894"/>
                <a:gd name="connsiteX36" fmla="*/ 885936 w 1159900"/>
                <a:gd name="connsiteY36" fmla="*/ 252616 h 298894"/>
                <a:gd name="connsiteX37" fmla="*/ 907284 w 1159900"/>
                <a:gd name="connsiteY37" fmla="*/ 238385 h 298894"/>
                <a:gd name="connsiteX38" fmla="*/ 917958 w 1159900"/>
                <a:gd name="connsiteY38" fmla="*/ 227711 h 298894"/>
                <a:gd name="connsiteX39" fmla="*/ 942864 w 1159900"/>
                <a:gd name="connsiteY39" fmla="*/ 220595 h 298894"/>
                <a:gd name="connsiteX40" fmla="*/ 964211 w 1159900"/>
                <a:gd name="connsiteY40" fmla="*/ 213479 h 298894"/>
                <a:gd name="connsiteX41" fmla="*/ 974885 w 1159900"/>
                <a:gd name="connsiteY41" fmla="*/ 209921 h 298894"/>
                <a:gd name="connsiteX42" fmla="*/ 985559 w 1159900"/>
                <a:gd name="connsiteY42" fmla="*/ 202805 h 298894"/>
                <a:gd name="connsiteX43" fmla="*/ 1006907 w 1159900"/>
                <a:gd name="connsiteY43" fmla="*/ 195689 h 298894"/>
                <a:gd name="connsiteX44" fmla="*/ 1028255 w 1159900"/>
                <a:gd name="connsiteY44" fmla="*/ 177899 h 298894"/>
                <a:gd name="connsiteX45" fmla="*/ 1035371 w 1159900"/>
                <a:gd name="connsiteY45" fmla="*/ 167225 h 298894"/>
                <a:gd name="connsiteX46" fmla="*/ 1056719 w 1159900"/>
                <a:gd name="connsiteY46" fmla="*/ 152993 h 298894"/>
                <a:gd name="connsiteX47" fmla="*/ 1088741 w 1159900"/>
                <a:gd name="connsiteY47" fmla="*/ 131645 h 298894"/>
                <a:gd name="connsiteX48" fmla="*/ 1099415 w 1159900"/>
                <a:gd name="connsiteY48" fmla="*/ 124529 h 298894"/>
                <a:gd name="connsiteX49" fmla="*/ 1117204 w 1159900"/>
                <a:gd name="connsiteY49" fmla="*/ 103181 h 298894"/>
                <a:gd name="connsiteX50" fmla="*/ 1127878 w 1159900"/>
                <a:gd name="connsiteY50" fmla="*/ 92508 h 298894"/>
                <a:gd name="connsiteX51" fmla="*/ 1138552 w 1159900"/>
                <a:gd name="connsiteY51" fmla="*/ 71160 h 298894"/>
                <a:gd name="connsiteX52" fmla="*/ 1149226 w 1159900"/>
                <a:gd name="connsiteY52" fmla="*/ 64044 h 298894"/>
                <a:gd name="connsiteX53" fmla="*/ 1159900 w 1159900"/>
                <a:gd name="connsiteY53" fmla="*/ 53370 h 2988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</a:cxnLst>
              <a:rect l="l" t="t" r="r" b="b"/>
              <a:pathLst>
                <a:path w="1159900" h="298894">
                  <a:moveTo>
                    <a:pt x="0" y="0"/>
                  </a:moveTo>
                  <a:cubicBezTo>
                    <a:pt x="3558" y="1186"/>
                    <a:pt x="7745" y="1215"/>
                    <a:pt x="10674" y="3558"/>
                  </a:cubicBezTo>
                  <a:cubicBezTo>
                    <a:pt x="14013" y="6229"/>
                    <a:pt x="15052" y="10947"/>
                    <a:pt x="17790" y="14232"/>
                  </a:cubicBezTo>
                  <a:cubicBezTo>
                    <a:pt x="28041" y="26533"/>
                    <a:pt x="25983" y="24079"/>
                    <a:pt x="39138" y="28464"/>
                  </a:cubicBezTo>
                  <a:cubicBezTo>
                    <a:pt x="46254" y="35580"/>
                    <a:pt x="54903" y="41439"/>
                    <a:pt x="60485" y="49812"/>
                  </a:cubicBezTo>
                  <a:cubicBezTo>
                    <a:pt x="65229" y="56928"/>
                    <a:pt x="72013" y="63047"/>
                    <a:pt x="74717" y="71160"/>
                  </a:cubicBezTo>
                  <a:cubicBezTo>
                    <a:pt x="75903" y="74718"/>
                    <a:pt x="75623" y="79182"/>
                    <a:pt x="78275" y="81834"/>
                  </a:cubicBezTo>
                  <a:cubicBezTo>
                    <a:pt x="84322" y="87881"/>
                    <a:pt x="92507" y="91322"/>
                    <a:pt x="99623" y="96066"/>
                  </a:cubicBezTo>
                  <a:cubicBezTo>
                    <a:pt x="113415" y="105260"/>
                    <a:pt x="106243" y="101830"/>
                    <a:pt x="120971" y="106739"/>
                  </a:cubicBezTo>
                  <a:cubicBezTo>
                    <a:pt x="151561" y="127132"/>
                    <a:pt x="112858" y="102682"/>
                    <a:pt x="142319" y="117413"/>
                  </a:cubicBezTo>
                  <a:cubicBezTo>
                    <a:pt x="169908" y="131208"/>
                    <a:pt x="136838" y="119144"/>
                    <a:pt x="163667" y="128087"/>
                  </a:cubicBezTo>
                  <a:cubicBezTo>
                    <a:pt x="168411" y="131645"/>
                    <a:pt x="173074" y="135314"/>
                    <a:pt x="177899" y="138761"/>
                  </a:cubicBezTo>
                  <a:cubicBezTo>
                    <a:pt x="181379" y="141246"/>
                    <a:pt x="185288" y="143139"/>
                    <a:pt x="188573" y="145877"/>
                  </a:cubicBezTo>
                  <a:cubicBezTo>
                    <a:pt x="198150" y="153858"/>
                    <a:pt x="198560" y="158618"/>
                    <a:pt x="209920" y="163667"/>
                  </a:cubicBezTo>
                  <a:cubicBezTo>
                    <a:pt x="236104" y="175304"/>
                    <a:pt x="224697" y="165417"/>
                    <a:pt x="245500" y="177899"/>
                  </a:cubicBezTo>
                  <a:cubicBezTo>
                    <a:pt x="252834" y="182299"/>
                    <a:pt x="258735" y="189427"/>
                    <a:pt x="266848" y="192131"/>
                  </a:cubicBezTo>
                  <a:lnTo>
                    <a:pt x="288196" y="199247"/>
                  </a:lnTo>
                  <a:cubicBezTo>
                    <a:pt x="316522" y="218131"/>
                    <a:pt x="301078" y="212270"/>
                    <a:pt x="334450" y="217037"/>
                  </a:cubicBezTo>
                  <a:cubicBezTo>
                    <a:pt x="338008" y="219409"/>
                    <a:pt x="341194" y="222468"/>
                    <a:pt x="345124" y="224153"/>
                  </a:cubicBezTo>
                  <a:cubicBezTo>
                    <a:pt x="349618" y="226079"/>
                    <a:pt x="354672" y="226306"/>
                    <a:pt x="359355" y="227711"/>
                  </a:cubicBezTo>
                  <a:cubicBezTo>
                    <a:pt x="366540" y="229866"/>
                    <a:pt x="373587" y="232455"/>
                    <a:pt x="380703" y="234827"/>
                  </a:cubicBezTo>
                  <a:lnTo>
                    <a:pt x="391377" y="238385"/>
                  </a:lnTo>
                  <a:lnTo>
                    <a:pt x="412725" y="252616"/>
                  </a:lnTo>
                  <a:cubicBezTo>
                    <a:pt x="416283" y="254988"/>
                    <a:pt x="419342" y="258380"/>
                    <a:pt x="423399" y="259732"/>
                  </a:cubicBezTo>
                  <a:lnTo>
                    <a:pt x="444747" y="266848"/>
                  </a:lnTo>
                  <a:cubicBezTo>
                    <a:pt x="448305" y="269220"/>
                    <a:pt x="451596" y="272052"/>
                    <a:pt x="455421" y="273964"/>
                  </a:cubicBezTo>
                  <a:cubicBezTo>
                    <a:pt x="465357" y="278932"/>
                    <a:pt x="481823" y="279769"/>
                    <a:pt x="491001" y="281080"/>
                  </a:cubicBezTo>
                  <a:cubicBezTo>
                    <a:pt x="544440" y="298894"/>
                    <a:pt x="502333" y="287088"/>
                    <a:pt x="611972" y="291754"/>
                  </a:cubicBezTo>
                  <a:cubicBezTo>
                    <a:pt x="634516" y="292713"/>
                    <a:pt x="657039" y="294126"/>
                    <a:pt x="679573" y="295312"/>
                  </a:cubicBezTo>
                  <a:cubicBezTo>
                    <a:pt x="705665" y="294126"/>
                    <a:pt x="731813" y="293837"/>
                    <a:pt x="757849" y="291754"/>
                  </a:cubicBezTo>
                  <a:cubicBezTo>
                    <a:pt x="761588" y="291455"/>
                    <a:pt x="764845" y="288932"/>
                    <a:pt x="768523" y="288196"/>
                  </a:cubicBezTo>
                  <a:cubicBezTo>
                    <a:pt x="776746" y="286551"/>
                    <a:pt x="785127" y="285824"/>
                    <a:pt x="793429" y="284638"/>
                  </a:cubicBezTo>
                  <a:cubicBezTo>
                    <a:pt x="820259" y="275695"/>
                    <a:pt x="787188" y="287759"/>
                    <a:pt x="814776" y="273964"/>
                  </a:cubicBezTo>
                  <a:cubicBezTo>
                    <a:pt x="820463" y="271121"/>
                    <a:pt x="834363" y="268368"/>
                    <a:pt x="839682" y="266848"/>
                  </a:cubicBezTo>
                  <a:cubicBezTo>
                    <a:pt x="843288" y="265818"/>
                    <a:pt x="846750" y="264320"/>
                    <a:pt x="850356" y="263290"/>
                  </a:cubicBezTo>
                  <a:cubicBezTo>
                    <a:pt x="855058" y="261947"/>
                    <a:pt x="859904" y="261137"/>
                    <a:pt x="864588" y="259732"/>
                  </a:cubicBezTo>
                  <a:cubicBezTo>
                    <a:pt x="871773" y="257577"/>
                    <a:pt x="885936" y="252616"/>
                    <a:pt x="885936" y="252616"/>
                  </a:cubicBezTo>
                  <a:cubicBezTo>
                    <a:pt x="919992" y="218563"/>
                    <a:pt x="876385" y="258984"/>
                    <a:pt x="907284" y="238385"/>
                  </a:cubicBezTo>
                  <a:cubicBezTo>
                    <a:pt x="911471" y="235594"/>
                    <a:pt x="913771" y="230502"/>
                    <a:pt x="917958" y="227711"/>
                  </a:cubicBezTo>
                  <a:cubicBezTo>
                    <a:pt x="921219" y="225537"/>
                    <a:pt x="940707" y="221242"/>
                    <a:pt x="942864" y="220595"/>
                  </a:cubicBezTo>
                  <a:cubicBezTo>
                    <a:pt x="950048" y="218440"/>
                    <a:pt x="957095" y="215851"/>
                    <a:pt x="964211" y="213479"/>
                  </a:cubicBezTo>
                  <a:lnTo>
                    <a:pt x="974885" y="209921"/>
                  </a:lnTo>
                  <a:cubicBezTo>
                    <a:pt x="978443" y="207549"/>
                    <a:pt x="981651" y="204542"/>
                    <a:pt x="985559" y="202805"/>
                  </a:cubicBezTo>
                  <a:cubicBezTo>
                    <a:pt x="992413" y="199759"/>
                    <a:pt x="1006907" y="195689"/>
                    <a:pt x="1006907" y="195689"/>
                  </a:cubicBezTo>
                  <a:cubicBezTo>
                    <a:pt x="1017402" y="188692"/>
                    <a:pt x="1019694" y="188172"/>
                    <a:pt x="1028255" y="177899"/>
                  </a:cubicBezTo>
                  <a:cubicBezTo>
                    <a:pt x="1030993" y="174614"/>
                    <a:pt x="1032153" y="170041"/>
                    <a:pt x="1035371" y="167225"/>
                  </a:cubicBezTo>
                  <a:cubicBezTo>
                    <a:pt x="1041807" y="161593"/>
                    <a:pt x="1049603" y="157737"/>
                    <a:pt x="1056719" y="152993"/>
                  </a:cubicBezTo>
                  <a:lnTo>
                    <a:pt x="1088741" y="131645"/>
                  </a:lnTo>
                  <a:cubicBezTo>
                    <a:pt x="1092299" y="129273"/>
                    <a:pt x="1096391" y="127553"/>
                    <a:pt x="1099415" y="124529"/>
                  </a:cubicBezTo>
                  <a:cubicBezTo>
                    <a:pt x="1130608" y="93336"/>
                    <a:pt x="1092430" y="132910"/>
                    <a:pt x="1117204" y="103181"/>
                  </a:cubicBezTo>
                  <a:cubicBezTo>
                    <a:pt x="1120425" y="99316"/>
                    <a:pt x="1124320" y="96066"/>
                    <a:pt x="1127878" y="92508"/>
                  </a:cubicBezTo>
                  <a:cubicBezTo>
                    <a:pt x="1130772" y="83827"/>
                    <a:pt x="1131655" y="78057"/>
                    <a:pt x="1138552" y="71160"/>
                  </a:cubicBezTo>
                  <a:cubicBezTo>
                    <a:pt x="1141576" y="68136"/>
                    <a:pt x="1145668" y="66416"/>
                    <a:pt x="1149226" y="64044"/>
                  </a:cubicBezTo>
                  <a:cubicBezTo>
                    <a:pt x="1157000" y="52383"/>
                    <a:pt x="1152066" y="53370"/>
                    <a:pt x="1159900" y="53370"/>
                  </a:cubicBezTo>
                </a:path>
              </a:pathLst>
            </a:custGeom>
            <a:ln w="6350"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" name="Right Brace 25"/>
            <p:cNvSpPr/>
            <p:nvPr/>
          </p:nvSpPr>
          <p:spPr>
            <a:xfrm>
              <a:off x="3322838" y="1035984"/>
              <a:ext cx="45719" cy="313726"/>
            </a:xfrm>
            <a:prstGeom prst="rightBrace">
              <a:avLst>
                <a:gd name="adj1" fmla="val 40476"/>
                <a:gd name="adj2" fmla="val 50000"/>
              </a:avLst>
            </a:prstGeom>
            <a:noFill/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Right Brace 26"/>
            <p:cNvSpPr/>
            <p:nvPr/>
          </p:nvSpPr>
          <p:spPr>
            <a:xfrm>
              <a:off x="3322838" y="1360015"/>
              <a:ext cx="45719" cy="459283"/>
            </a:xfrm>
            <a:prstGeom prst="rightBrace">
              <a:avLst>
                <a:gd name="adj1" fmla="val 40476"/>
                <a:gd name="adj2" fmla="val 50000"/>
              </a:avLst>
            </a:prstGeom>
            <a:noFill/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289726" y="732434"/>
              <a:ext cx="381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altLang="zh-HK" sz="10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PZ</a:t>
              </a:r>
              <a:endParaRPr lang="zh-HK" alt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286123" y="1080544"/>
              <a:ext cx="4415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altLang="zh-HK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PHZ</a:t>
              </a:r>
              <a:endParaRPr lang="zh-HK" alt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288789" y="1467750"/>
              <a:ext cx="378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altLang="zh-HK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HZ</a:t>
              </a:r>
              <a:endParaRPr lang="zh-HK" alt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 Box 1300"/>
            <p:cNvSpPr txBox="1">
              <a:spLocks noChangeArrowheads="1"/>
            </p:cNvSpPr>
            <p:nvPr/>
          </p:nvSpPr>
          <p:spPr bwMode="auto">
            <a:xfrm>
              <a:off x="3168152" y="2529753"/>
              <a:ext cx="532310" cy="2836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lIns="92930" tIns="46465" rIns="92930" bIns="46465">
              <a:spAutoFit/>
            </a:bodyPr>
            <a:lstStyle/>
            <a:p>
              <a:pPr algn="ctr" defTabSz="2927049">
                <a:spcBef>
                  <a:spcPct val="50000"/>
                </a:spcBef>
                <a:defRPr/>
              </a:pPr>
              <a:r>
                <a:rPr lang="en-US" sz="1200" b="1" i="1" kern="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Gli1</a:t>
              </a:r>
              <a:endParaRPr lang="en-US" sz="1200" b="1" i="1" kern="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725793" y="655637"/>
            <a:ext cx="3260997" cy="2163762"/>
            <a:chOff x="3725793" y="655637"/>
            <a:chExt cx="3260997" cy="2163762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25793" y="655637"/>
              <a:ext cx="3200400" cy="21637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1" name="Right Brace 30"/>
            <p:cNvSpPr/>
            <p:nvPr/>
          </p:nvSpPr>
          <p:spPr>
            <a:xfrm>
              <a:off x="6578530" y="685800"/>
              <a:ext cx="45719" cy="339491"/>
            </a:xfrm>
            <a:prstGeom prst="rightBrace">
              <a:avLst>
                <a:gd name="adj1" fmla="val 40476"/>
                <a:gd name="adj2" fmla="val 50000"/>
              </a:avLst>
            </a:prstGeom>
            <a:noFill/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" name="Freeform 31"/>
            <p:cNvSpPr/>
            <p:nvPr/>
          </p:nvSpPr>
          <p:spPr>
            <a:xfrm>
              <a:off x="3987730" y="990601"/>
              <a:ext cx="2743200" cy="69380"/>
            </a:xfrm>
            <a:custGeom>
              <a:avLst/>
              <a:gdLst>
                <a:gd name="connsiteX0" fmla="*/ 0 w 928632"/>
                <a:gd name="connsiteY0" fmla="*/ 0 h 128087"/>
                <a:gd name="connsiteX1" fmla="*/ 10674 w 928632"/>
                <a:gd name="connsiteY1" fmla="*/ 3558 h 128087"/>
                <a:gd name="connsiteX2" fmla="*/ 32022 w 928632"/>
                <a:gd name="connsiteY2" fmla="*/ 17790 h 128087"/>
                <a:gd name="connsiteX3" fmla="*/ 53370 w 928632"/>
                <a:gd name="connsiteY3" fmla="*/ 24906 h 128087"/>
                <a:gd name="connsiteX4" fmla="*/ 64044 w 928632"/>
                <a:gd name="connsiteY4" fmla="*/ 32022 h 128087"/>
                <a:gd name="connsiteX5" fmla="*/ 85392 w 928632"/>
                <a:gd name="connsiteY5" fmla="*/ 39138 h 128087"/>
                <a:gd name="connsiteX6" fmla="*/ 96066 w 928632"/>
                <a:gd name="connsiteY6" fmla="*/ 46253 h 128087"/>
                <a:gd name="connsiteX7" fmla="*/ 113856 w 928632"/>
                <a:gd name="connsiteY7" fmla="*/ 49811 h 128087"/>
                <a:gd name="connsiteX8" fmla="*/ 149435 w 928632"/>
                <a:gd name="connsiteY8" fmla="*/ 56927 h 128087"/>
                <a:gd name="connsiteX9" fmla="*/ 160109 w 928632"/>
                <a:gd name="connsiteY9" fmla="*/ 60485 h 128087"/>
                <a:gd name="connsiteX10" fmla="*/ 195689 w 928632"/>
                <a:gd name="connsiteY10" fmla="*/ 67601 h 128087"/>
                <a:gd name="connsiteX11" fmla="*/ 206363 w 928632"/>
                <a:gd name="connsiteY11" fmla="*/ 71159 h 128087"/>
                <a:gd name="connsiteX12" fmla="*/ 234827 w 928632"/>
                <a:gd name="connsiteY12" fmla="*/ 78275 h 128087"/>
                <a:gd name="connsiteX13" fmla="*/ 266849 w 928632"/>
                <a:gd name="connsiteY13" fmla="*/ 88949 h 128087"/>
                <a:gd name="connsiteX14" fmla="*/ 288196 w 928632"/>
                <a:gd name="connsiteY14" fmla="*/ 92507 h 128087"/>
                <a:gd name="connsiteX15" fmla="*/ 302428 w 928632"/>
                <a:gd name="connsiteY15" fmla="*/ 96065 h 128087"/>
                <a:gd name="connsiteX16" fmla="*/ 352240 w 928632"/>
                <a:gd name="connsiteY16" fmla="*/ 103181 h 128087"/>
                <a:gd name="connsiteX17" fmla="*/ 387820 w 928632"/>
                <a:gd name="connsiteY17" fmla="*/ 113855 h 128087"/>
                <a:gd name="connsiteX18" fmla="*/ 434074 w 928632"/>
                <a:gd name="connsiteY18" fmla="*/ 117413 h 128087"/>
                <a:gd name="connsiteX19" fmla="*/ 523023 w 928632"/>
                <a:gd name="connsiteY19" fmla="*/ 128087 h 128087"/>
                <a:gd name="connsiteX20" fmla="*/ 676016 w 928632"/>
                <a:gd name="connsiteY20" fmla="*/ 120971 h 128087"/>
                <a:gd name="connsiteX21" fmla="*/ 686690 w 928632"/>
                <a:gd name="connsiteY21" fmla="*/ 117413 h 128087"/>
                <a:gd name="connsiteX22" fmla="*/ 736502 w 928632"/>
                <a:gd name="connsiteY22" fmla="*/ 110297 h 128087"/>
                <a:gd name="connsiteX23" fmla="*/ 764965 w 928632"/>
                <a:gd name="connsiteY23" fmla="*/ 106739 h 128087"/>
                <a:gd name="connsiteX24" fmla="*/ 779197 w 928632"/>
                <a:gd name="connsiteY24" fmla="*/ 103181 h 128087"/>
                <a:gd name="connsiteX25" fmla="*/ 807661 w 928632"/>
                <a:gd name="connsiteY25" fmla="*/ 99623 h 128087"/>
                <a:gd name="connsiteX26" fmla="*/ 829009 w 928632"/>
                <a:gd name="connsiteY26" fmla="*/ 85391 h 128087"/>
                <a:gd name="connsiteX27" fmla="*/ 839683 w 928632"/>
                <a:gd name="connsiteY27" fmla="*/ 81833 h 128087"/>
                <a:gd name="connsiteX28" fmla="*/ 882379 w 928632"/>
                <a:gd name="connsiteY28" fmla="*/ 74717 h 128087"/>
                <a:gd name="connsiteX29" fmla="*/ 896610 w 928632"/>
                <a:gd name="connsiteY29" fmla="*/ 71159 h 128087"/>
                <a:gd name="connsiteX30" fmla="*/ 917958 w 928632"/>
                <a:gd name="connsiteY30" fmla="*/ 67601 h 128087"/>
                <a:gd name="connsiteX31" fmla="*/ 928632 w 928632"/>
                <a:gd name="connsiteY31" fmla="*/ 64043 h 1280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928632" h="128087">
                  <a:moveTo>
                    <a:pt x="0" y="0"/>
                  </a:moveTo>
                  <a:cubicBezTo>
                    <a:pt x="3558" y="1186"/>
                    <a:pt x="7396" y="1737"/>
                    <a:pt x="10674" y="3558"/>
                  </a:cubicBezTo>
                  <a:cubicBezTo>
                    <a:pt x="18150" y="7711"/>
                    <a:pt x="23909" y="15086"/>
                    <a:pt x="32022" y="17790"/>
                  </a:cubicBezTo>
                  <a:lnTo>
                    <a:pt x="53370" y="24906"/>
                  </a:lnTo>
                  <a:cubicBezTo>
                    <a:pt x="56928" y="27278"/>
                    <a:pt x="60136" y="30285"/>
                    <a:pt x="64044" y="32022"/>
                  </a:cubicBezTo>
                  <a:cubicBezTo>
                    <a:pt x="70898" y="35068"/>
                    <a:pt x="79151" y="34978"/>
                    <a:pt x="85392" y="39138"/>
                  </a:cubicBezTo>
                  <a:cubicBezTo>
                    <a:pt x="88950" y="41510"/>
                    <a:pt x="92062" y="44752"/>
                    <a:pt x="96066" y="46253"/>
                  </a:cubicBezTo>
                  <a:cubicBezTo>
                    <a:pt x="101728" y="48376"/>
                    <a:pt x="107989" y="48344"/>
                    <a:pt x="113856" y="49811"/>
                  </a:cubicBezTo>
                  <a:cubicBezTo>
                    <a:pt x="146976" y="58091"/>
                    <a:pt x="88417" y="48210"/>
                    <a:pt x="149435" y="56927"/>
                  </a:cubicBezTo>
                  <a:cubicBezTo>
                    <a:pt x="152993" y="58113"/>
                    <a:pt x="156448" y="59671"/>
                    <a:pt x="160109" y="60485"/>
                  </a:cubicBezTo>
                  <a:cubicBezTo>
                    <a:pt x="191562" y="67475"/>
                    <a:pt x="170878" y="60512"/>
                    <a:pt x="195689" y="67601"/>
                  </a:cubicBezTo>
                  <a:cubicBezTo>
                    <a:pt x="199295" y="68631"/>
                    <a:pt x="202745" y="70172"/>
                    <a:pt x="206363" y="71159"/>
                  </a:cubicBezTo>
                  <a:cubicBezTo>
                    <a:pt x="215798" y="73732"/>
                    <a:pt x="225549" y="75182"/>
                    <a:pt x="234827" y="78275"/>
                  </a:cubicBezTo>
                  <a:lnTo>
                    <a:pt x="266849" y="88949"/>
                  </a:lnTo>
                  <a:cubicBezTo>
                    <a:pt x="273693" y="91230"/>
                    <a:pt x="281122" y="91092"/>
                    <a:pt x="288196" y="92507"/>
                  </a:cubicBezTo>
                  <a:cubicBezTo>
                    <a:pt x="292991" y="93466"/>
                    <a:pt x="297605" y="95261"/>
                    <a:pt x="302428" y="96065"/>
                  </a:cubicBezTo>
                  <a:cubicBezTo>
                    <a:pt x="341782" y="102624"/>
                    <a:pt x="318645" y="96462"/>
                    <a:pt x="352240" y="103181"/>
                  </a:cubicBezTo>
                  <a:cubicBezTo>
                    <a:pt x="365683" y="105870"/>
                    <a:pt x="374205" y="109317"/>
                    <a:pt x="387820" y="113855"/>
                  </a:cubicBezTo>
                  <a:cubicBezTo>
                    <a:pt x="402490" y="118745"/>
                    <a:pt x="418656" y="116227"/>
                    <a:pt x="434074" y="117413"/>
                  </a:cubicBezTo>
                  <a:cubicBezTo>
                    <a:pt x="487136" y="128026"/>
                    <a:pt x="457585" y="123724"/>
                    <a:pt x="523023" y="128087"/>
                  </a:cubicBezTo>
                  <a:lnTo>
                    <a:pt x="676016" y="120971"/>
                  </a:lnTo>
                  <a:cubicBezTo>
                    <a:pt x="679762" y="120797"/>
                    <a:pt x="682997" y="118065"/>
                    <a:pt x="686690" y="117413"/>
                  </a:cubicBezTo>
                  <a:cubicBezTo>
                    <a:pt x="703207" y="114498"/>
                    <a:pt x="719859" y="112377"/>
                    <a:pt x="736502" y="110297"/>
                  </a:cubicBezTo>
                  <a:cubicBezTo>
                    <a:pt x="745990" y="109111"/>
                    <a:pt x="755534" y="108311"/>
                    <a:pt x="764965" y="106739"/>
                  </a:cubicBezTo>
                  <a:cubicBezTo>
                    <a:pt x="769788" y="105935"/>
                    <a:pt x="774374" y="103985"/>
                    <a:pt x="779197" y="103181"/>
                  </a:cubicBezTo>
                  <a:cubicBezTo>
                    <a:pt x="788629" y="101609"/>
                    <a:pt x="798173" y="100809"/>
                    <a:pt x="807661" y="99623"/>
                  </a:cubicBezTo>
                  <a:lnTo>
                    <a:pt x="829009" y="85391"/>
                  </a:lnTo>
                  <a:cubicBezTo>
                    <a:pt x="832130" y="83311"/>
                    <a:pt x="836077" y="82863"/>
                    <a:pt x="839683" y="81833"/>
                  </a:cubicBezTo>
                  <a:cubicBezTo>
                    <a:pt x="857967" y="76609"/>
                    <a:pt x="859278" y="77605"/>
                    <a:pt x="882379" y="74717"/>
                  </a:cubicBezTo>
                  <a:cubicBezTo>
                    <a:pt x="887123" y="73531"/>
                    <a:pt x="891815" y="72118"/>
                    <a:pt x="896610" y="71159"/>
                  </a:cubicBezTo>
                  <a:cubicBezTo>
                    <a:pt x="903684" y="69744"/>
                    <a:pt x="910916" y="69166"/>
                    <a:pt x="917958" y="67601"/>
                  </a:cubicBezTo>
                  <a:cubicBezTo>
                    <a:pt x="921619" y="66787"/>
                    <a:pt x="928632" y="64043"/>
                    <a:pt x="928632" y="64043"/>
                  </a:cubicBezTo>
                </a:path>
              </a:pathLst>
            </a:custGeom>
            <a:ln w="6350"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Freeform 32"/>
            <p:cNvSpPr/>
            <p:nvPr/>
          </p:nvSpPr>
          <p:spPr>
            <a:xfrm>
              <a:off x="3802267" y="1205730"/>
              <a:ext cx="3075012" cy="242070"/>
            </a:xfrm>
            <a:custGeom>
              <a:avLst/>
              <a:gdLst>
                <a:gd name="connsiteX0" fmla="*/ 0 w 1067923"/>
                <a:gd name="connsiteY0" fmla="*/ 0 h 174620"/>
                <a:gd name="connsiteX1" fmla="*/ 32022 w 1067923"/>
                <a:gd name="connsiteY1" fmla="*/ 21348 h 174620"/>
                <a:gd name="connsiteX2" fmla="*/ 42695 w 1067923"/>
                <a:gd name="connsiteY2" fmla="*/ 28464 h 174620"/>
                <a:gd name="connsiteX3" fmla="*/ 64043 w 1067923"/>
                <a:gd name="connsiteY3" fmla="*/ 46254 h 174620"/>
                <a:gd name="connsiteX4" fmla="*/ 85391 w 1067923"/>
                <a:gd name="connsiteY4" fmla="*/ 53369 h 174620"/>
                <a:gd name="connsiteX5" fmla="*/ 96065 w 1067923"/>
                <a:gd name="connsiteY5" fmla="*/ 56927 h 174620"/>
                <a:gd name="connsiteX6" fmla="*/ 113855 w 1067923"/>
                <a:gd name="connsiteY6" fmla="*/ 74717 h 174620"/>
                <a:gd name="connsiteX7" fmla="*/ 145877 w 1067923"/>
                <a:gd name="connsiteY7" fmla="*/ 88949 h 174620"/>
                <a:gd name="connsiteX8" fmla="*/ 167225 w 1067923"/>
                <a:gd name="connsiteY8" fmla="*/ 96065 h 174620"/>
                <a:gd name="connsiteX9" fmla="*/ 177899 w 1067923"/>
                <a:gd name="connsiteY9" fmla="*/ 99623 h 174620"/>
                <a:gd name="connsiteX10" fmla="*/ 188573 w 1067923"/>
                <a:gd name="connsiteY10" fmla="*/ 106739 h 174620"/>
                <a:gd name="connsiteX11" fmla="*/ 252616 w 1067923"/>
                <a:gd name="connsiteY11" fmla="*/ 113855 h 174620"/>
                <a:gd name="connsiteX12" fmla="*/ 284638 w 1067923"/>
                <a:gd name="connsiteY12" fmla="*/ 124529 h 174620"/>
                <a:gd name="connsiteX13" fmla="*/ 320218 w 1067923"/>
                <a:gd name="connsiteY13" fmla="*/ 131645 h 174620"/>
                <a:gd name="connsiteX14" fmla="*/ 338008 w 1067923"/>
                <a:gd name="connsiteY14" fmla="*/ 135203 h 174620"/>
                <a:gd name="connsiteX15" fmla="*/ 359355 w 1067923"/>
                <a:gd name="connsiteY15" fmla="*/ 138761 h 174620"/>
                <a:gd name="connsiteX16" fmla="*/ 370029 w 1067923"/>
                <a:gd name="connsiteY16" fmla="*/ 142319 h 174620"/>
                <a:gd name="connsiteX17" fmla="*/ 405609 w 1067923"/>
                <a:gd name="connsiteY17" fmla="*/ 149435 h 174620"/>
                <a:gd name="connsiteX18" fmla="*/ 426957 w 1067923"/>
                <a:gd name="connsiteY18" fmla="*/ 156551 h 174620"/>
                <a:gd name="connsiteX19" fmla="*/ 483885 w 1067923"/>
                <a:gd name="connsiteY19" fmla="*/ 163667 h 174620"/>
                <a:gd name="connsiteX20" fmla="*/ 494559 w 1067923"/>
                <a:gd name="connsiteY20" fmla="*/ 167225 h 174620"/>
                <a:gd name="connsiteX21" fmla="*/ 597740 w 1067923"/>
                <a:gd name="connsiteY21" fmla="*/ 174341 h 174620"/>
                <a:gd name="connsiteX22" fmla="*/ 750733 w 1067923"/>
                <a:gd name="connsiteY22" fmla="*/ 170783 h 174620"/>
                <a:gd name="connsiteX23" fmla="*/ 786313 w 1067923"/>
                <a:gd name="connsiteY23" fmla="*/ 163667 h 174620"/>
                <a:gd name="connsiteX24" fmla="*/ 800545 w 1067923"/>
                <a:gd name="connsiteY24" fmla="*/ 160109 h 174620"/>
                <a:gd name="connsiteX25" fmla="*/ 811218 w 1067923"/>
                <a:gd name="connsiteY25" fmla="*/ 156551 h 174620"/>
                <a:gd name="connsiteX26" fmla="*/ 853914 w 1067923"/>
                <a:gd name="connsiteY26" fmla="*/ 149435 h 174620"/>
                <a:gd name="connsiteX27" fmla="*/ 882378 w 1067923"/>
                <a:gd name="connsiteY27" fmla="*/ 142319 h 174620"/>
                <a:gd name="connsiteX28" fmla="*/ 910842 w 1067923"/>
                <a:gd name="connsiteY28" fmla="*/ 135203 h 174620"/>
                <a:gd name="connsiteX29" fmla="*/ 921516 w 1067923"/>
                <a:gd name="connsiteY29" fmla="*/ 124529 h 174620"/>
                <a:gd name="connsiteX30" fmla="*/ 942864 w 1067923"/>
                <a:gd name="connsiteY30" fmla="*/ 117413 h 174620"/>
                <a:gd name="connsiteX31" fmla="*/ 974885 w 1067923"/>
                <a:gd name="connsiteY31" fmla="*/ 106739 h 174620"/>
                <a:gd name="connsiteX32" fmla="*/ 996233 w 1067923"/>
                <a:gd name="connsiteY32" fmla="*/ 99623 h 174620"/>
                <a:gd name="connsiteX33" fmla="*/ 1006907 w 1067923"/>
                <a:gd name="connsiteY33" fmla="*/ 96065 h 174620"/>
                <a:gd name="connsiteX34" fmla="*/ 1017581 w 1067923"/>
                <a:gd name="connsiteY34" fmla="*/ 88949 h 174620"/>
                <a:gd name="connsiteX35" fmla="*/ 1038929 w 1067923"/>
                <a:gd name="connsiteY35" fmla="*/ 81833 h 174620"/>
                <a:gd name="connsiteX36" fmla="*/ 1049603 w 1067923"/>
                <a:gd name="connsiteY36" fmla="*/ 74717 h 174620"/>
                <a:gd name="connsiteX37" fmla="*/ 1067393 w 1067923"/>
                <a:gd name="connsiteY37" fmla="*/ 60485 h 174620"/>
                <a:gd name="connsiteX38" fmla="*/ 1067393 w 1067923"/>
                <a:gd name="connsiteY38" fmla="*/ 56927 h 1746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</a:cxnLst>
              <a:rect l="l" t="t" r="r" b="b"/>
              <a:pathLst>
                <a:path w="1067923" h="174620">
                  <a:moveTo>
                    <a:pt x="0" y="0"/>
                  </a:moveTo>
                  <a:lnTo>
                    <a:pt x="32022" y="21348"/>
                  </a:lnTo>
                  <a:cubicBezTo>
                    <a:pt x="35580" y="23720"/>
                    <a:pt x="39671" y="25440"/>
                    <a:pt x="42695" y="28464"/>
                  </a:cubicBezTo>
                  <a:cubicBezTo>
                    <a:pt x="49398" y="35167"/>
                    <a:pt x="55127" y="42292"/>
                    <a:pt x="64043" y="46254"/>
                  </a:cubicBezTo>
                  <a:cubicBezTo>
                    <a:pt x="70897" y="49300"/>
                    <a:pt x="78275" y="50997"/>
                    <a:pt x="85391" y="53369"/>
                  </a:cubicBezTo>
                  <a:lnTo>
                    <a:pt x="96065" y="56927"/>
                  </a:lnTo>
                  <a:cubicBezTo>
                    <a:pt x="124529" y="75903"/>
                    <a:pt x="90135" y="50997"/>
                    <a:pt x="113855" y="74717"/>
                  </a:cubicBezTo>
                  <a:cubicBezTo>
                    <a:pt x="122313" y="83175"/>
                    <a:pt x="135308" y="85426"/>
                    <a:pt x="145877" y="88949"/>
                  </a:cubicBezTo>
                  <a:lnTo>
                    <a:pt x="167225" y="96065"/>
                  </a:lnTo>
                  <a:lnTo>
                    <a:pt x="177899" y="99623"/>
                  </a:lnTo>
                  <a:cubicBezTo>
                    <a:pt x="181457" y="101995"/>
                    <a:pt x="184447" y="105614"/>
                    <a:pt x="188573" y="106739"/>
                  </a:cubicBezTo>
                  <a:cubicBezTo>
                    <a:pt x="194405" y="108330"/>
                    <a:pt x="250476" y="113641"/>
                    <a:pt x="252616" y="113855"/>
                  </a:cubicBezTo>
                  <a:lnTo>
                    <a:pt x="284638" y="124529"/>
                  </a:lnTo>
                  <a:cubicBezTo>
                    <a:pt x="296112" y="128354"/>
                    <a:pt x="308358" y="129273"/>
                    <a:pt x="320218" y="131645"/>
                  </a:cubicBezTo>
                  <a:lnTo>
                    <a:pt x="338008" y="135203"/>
                  </a:lnTo>
                  <a:cubicBezTo>
                    <a:pt x="345082" y="136618"/>
                    <a:pt x="352313" y="137196"/>
                    <a:pt x="359355" y="138761"/>
                  </a:cubicBezTo>
                  <a:cubicBezTo>
                    <a:pt x="363016" y="139575"/>
                    <a:pt x="366375" y="141476"/>
                    <a:pt x="370029" y="142319"/>
                  </a:cubicBezTo>
                  <a:cubicBezTo>
                    <a:pt x="381814" y="145039"/>
                    <a:pt x="394135" y="145610"/>
                    <a:pt x="405609" y="149435"/>
                  </a:cubicBezTo>
                  <a:cubicBezTo>
                    <a:pt x="412725" y="151807"/>
                    <a:pt x="419514" y="155621"/>
                    <a:pt x="426957" y="156551"/>
                  </a:cubicBezTo>
                  <a:lnTo>
                    <a:pt x="483885" y="163667"/>
                  </a:lnTo>
                  <a:cubicBezTo>
                    <a:pt x="487443" y="164853"/>
                    <a:pt x="490898" y="166411"/>
                    <a:pt x="494559" y="167225"/>
                  </a:cubicBezTo>
                  <a:cubicBezTo>
                    <a:pt x="527833" y="174620"/>
                    <a:pt x="565491" y="172939"/>
                    <a:pt x="597740" y="174341"/>
                  </a:cubicBezTo>
                  <a:lnTo>
                    <a:pt x="750733" y="170783"/>
                  </a:lnTo>
                  <a:cubicBezTo>
                    <a:pt x="775445" y="169795"/>
                    <a:pt x="769430" y="168491"/>
                    <a:pt x="786313" y="163667"/>
                  </a:cubicBezTo>
                  <a:cubicBezTo>
                    <a:pt x="791015" y="162324"/>
                    <a:pt x="795843" y="161452"/>
                    <a:pt x="800545" y="160109"/>
                  </a:cubicBezTo>
                  <a:cubicBezTo>
                    <a:pt x="804151" y="159079"/>
                    <a:pt x="807580" y="157461"/>
                    <a:pt x="811218" y="156551"/>
                  </a:cubicBezTo>
                  <a:cubicBezTo>
                    <a:pt x="836673" y="150187"/>
                    <a:pt x="823796" y="155459"/>
                    <a:pt x="853914" y="149435"/>
                  </a:cubicBezTo>
                  <a:cubicBezTo>
                    <a:pt x="863504" y="147517"/>
                    <a:pt x="872890" y="144691"/>
                    <a:pt x="882378" y="142319"/>
                  </a:cubicBezTo>
                  <a:lnTo>
                    <a:pt x="910842" y="135203"/>
                  </a:lnTo>
                  <a:cubicBezTo>
                    <a:pt x="914400" y="131645"/>
                    <a:pt x="917117" y="126973"/>
                    <a:pt x="921516" y="124529"/>
                  </a:cubicBezTo>
                  <a:cubicBezTo>
                    <a:pt x="928073" y="120886"/>
                    <a:pt x="935748" y="119785"/>
                    <a:pt x="942864" y="117413"/>
                  </a:cubicBezTo>
                  <a:lnTo>
                    <a:pt x="974885" y="106739"/>
                  </a:lnTo>
                  <a:lnTo>
                    <a:pt x="996233" y="99623"/>
                  </a:lnTo>
                  <a:lnTo>
                    <a:pt x="1006907" y="96065"/>
                  </a:lnTo>
                  <a:cubicBezTo>
                    <a:pt x="1010465" y="93693"/>
                    <a:pt x="1013673" y="90686"/>
                    <a:pt x="1017581" y="88949"/>
                  </a:cubicBezTo>
                  <a:cubicBezTo>
                    <a:pt x="1024435" y="85903"/>
                    <a:pt x="1038929" y="81833"/>
                    <a:pt x="1038929" y="81833"/>
                  </a:cubicBezTo>
                  <a:cubicBezTo>
                    <a:pt x="1042487" y="79461"/>
                    <a:pt x="1045778" y="76629"/>
                    <a:pt x="1049603" y="74717"/>
                  </a:cubicBezTo>
                  <a:cubicBezTo>
                    <a:pt x="1063282" y="67878"/>
                    <a:pt x="1059396" y="76479"/>
                    <a:pt x="1067393" y="60485"/>
                  </a:cubicBezTo>
                  <a:cubicBezTo>
                    <a:pt x="1067923" y="59424"/>
                    <a:pt x="1067393" y="58113"/>
                    <a:pt x="1067393" y="56927"/>
                  </a:cubicBezTo>
                </a:path>
              </a:pathLst>
            </a:custGeom>
            <a:ln w="6350"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" name="Freeform 33"/>
            <p:cNvSpPr/>
            <p:nvPr/>
          </p:nvSpPr>
          <p:spPr>
            <a:xfrm rot="21410453">
              <a:off x="3819953" y="1656868"/>
              <a:ext cx="3057311" cy="439759"/>
            </a:xfrm>
            <a:custGeom>
              <a:avLst/>
              <a:gdLst>
                <a:gd name="connsiteX0" fmla="*/ 0 w 1159900"/>
                <a:gd name="connsiteY0" fmla="*/ 0 h 298894"/>
                <a:gd name="connsiteX1" fmla="*/ 10674 w 1159900"/>
                <a:gd name="connsiteY1" fmla="*/ 3558 h 298894"/>
                <a:gd name="connsiteX2" fmla="*/ 17790 w 1159900"/>
                <a:gd name="connsiteY2" fmla="*/ 14232 h 298894"/>
                <a:gd name="connsiteX3" fmla="*/ 39138 w 1159900"/>
                <a:gd name="connsiteY3" fmla="*/ 28464 h 298894"/>
                <a:gd name="connsiteX4" fmla="*/ 60485 w 1159900"/>
                <a:gd name="connsiteY4" fmla="*/ 49812 h 298894"/>
                <a:gd name="connsiteX5" fmla="*/ 74717 w 1159900"/>
                <a:gd name="connsiteY5" fmla="*/ 71160 h 298894"/>
                <a:gd name="connsiteX6" fmla="*/ 78275 w 1159900"/>
                <a:gd name="connsiteY6" fmla="*/ 81834 h 298894"/>
                <a:gd name="connsiteX7" fmla="*/ 99623 w 1159900"/>
                <a:gd name="connsiteY7" fmla="*/ 96066 h 298894"/>
                <a:gd name="connsiteX8" fmla="*/ 120971 w 1159900"/>
                <a:gd name="connsiteY8" fmla="*/ 106739 h 298894"/>
                <a:gd name="connsiteX9" fmla="*/ 142319 w 1159900"/>
                <a:gd name="connsiteY9" fmla="*/ 117413 h 298894"/>
                <a:gd name="connsiteX10" fmla="*/ 163667 w 1159900"/>
                <a:gd name="connsiteY10" fmla="*/ 128087 h 298894"/>
                <a:gd name="connsiteX11" fmla="*/ 177899 w 1159900"/>
                <a:gd name="connsiteY11" fmla="*/ 138761 h 298894"/>
                <a:gd name="connsiteX12" fmla="*/ 188573 w 1159900"/>
                <a:gd name="connsiteY12" fmla="*/ 145877 h 298894"/>
                <a:gd name="connsiteX13" fmla="*/ 209920 w 1159900"/>
                <a:gd name="connsiteY13" fmla="*/ 163667 h 298894"/>
                <a:gd name="connsiteX14" fmla="*/ 245500 w 1159900"/>
                <a:gd name="connsiteY14" fmla="*/ 177899 h 298894"/>
                <a:gd name="connsiteX15" fmla="*/ 266848 w 1159900"/>
                <a:gd name="connsiteY15" fmla="*/ 192131 h 298894"/>
                <a:gd name="connsiteX16" fmla="*/ 288196 w 1159900"/>
                <a:gd name="connsiteY16" fmla="*/ 199247 h 298894"/>
                <a:gd name="connsiteX17" fmla="*/ 334450 w 1159900"/>
                <a:gd name="connsiteY17" fmla="*/ 217037 h 298894"/>
                <a:gd name="connsiteX18" fmla="*/ 345124 w 1159900"/>
                <a:gd name="connsiteY18" fmla="*/ 224153 h 298894"/>
                <a:gd name="connsiteX19" fmla="*/ 359355 w 1159900"/>
                <a:gd name="connsiteY19" fmla="*/ 227711 h 298894"/>
                <a:gd name="connsiteX20" fmla="*/ 380703 w 1159900"/>
                <a:gd name="connsiteY20" fmla="*/ 234827 h 298894"/>
                <a:gd name="connsiteX21" fmla="*/ 391377 w 1159900"/>
                <a:gd name="connsiteY21" fmla="*/ 238385 h 298894"/>
                <a:gd name="connsiteX22" fmla="*/ 412725 w 1159900"/>
                <a:gd name="connsiteY22" fmla="*/ 252616 h 298894"/>
                <a:gd name="connsiteX23" fmla="*/ 423399 w 1159900"/>
                <a:gd name="connsiteY23" fmla="*/ 259732 h 298894"/>
                <a:gd name="connsiteX24" fmla="*/ 444747 w 1159900"/>
                <a:gd name="connsiteY24" fmla="*/ 266848 h 298894"/>
                <a:gd name="connsiteX25" fmla="*/ 455421 w 1159900"/>
                <a:gd name="connsiteY25" fmla="*/ 273964 h 298894"/>
                <a:gd name="connsiteX26" fmla="*/ 491001 w 1159900"/>
                <a:gd name="connsiteY26" fmla="*/ 281080 h 298894"/>
                <a:gd name="connsiteX27" fmla="*/ 611972 w 1159900"/>
                <a:gd name="connsiteY27" fmla="*/ 291754 h 298894"/>
                <a:gd name="connsiteX28" fmla="*/ 679573 w 1159900"/>
                <a:gd name="connsiteY28" fmla="*/ 295312 h 298894"/>
                <a:gd name="connsiteX29" fmla="*/ 757849 w 1159900"/>
                <a:gd name="connsiteY29" fmla="*/ 291754 h 298894"/>
                <a:gd name="connsiteX30" fmla="*/ 768523 w 1159900"/>
                <a:gd name="connsiteY30" fmla="*/ 288196 h 298894"/>
                <a:gd name="connsiteX31" fmla="*/ 793429 w 1159900"/>
                <a:gd name="connsiteY31" fmla="*/ 284638 h 298894"/>
                <a:gd name="connsiteX32" fmla="*/ 814776 w 1159900"/>
                <a:gd name="connsiteY32" fmla="*/ 273964 h 298894"/>
                <a:gd name="connsiteX33" fmla="*/ 839682 w 1159900"/>
                <a:gd name="connsiteY33" fmla="*/ 266848 h 298894"/>
                <a:gd name="connsiteX34" fmla="*/ 850356 w 1159900"/>
                <a:gd name="connsiteY34" fmla="*/ 263290 h 298894"/>
                <a:gd name="connsiteX35" fmla="*/ 864588 w 1159900"/>
                <a:gd name="connsiteY35" fmla="*/ 259732 h 298894"/>
                <a:gd name="connsiteX36" fmla="*/ 885936 w 1159900"/>
                <a:gd name="connsiteY36" fmla="*/ 252616 h 298894"/>
                <a:gd name="connsiteX37" fmla="*/ 907284 w 1159900"/>
                <a:gd name="connsiteY37" fmla="*/ 238385 h 298894"/>
                <a:gd name="connsiteX38" fmla="*/ 917958 w 1159900"/>
                <a:gd name="connsiteY38" fmla="*/ 227711 h 298894"/>
                <a:gd name="connsiteX39" fmla="*/ 942864 w 1159900"/>
                <a:gd name="connsiteY39" fmla="*/ 220595 h 298894"/>
                <a:gd name="connsiteX40" fmla="*/ 964211 w 1159900"/>
                <a:gd name="connsiteY40" fmla="*/ 213479 h 298894"/>
                <a:gd name="connsiteX41" fmla="*/ 974885 w 1159900"/>
                <a:gd name="connsiteY41" fmla="*/ 209921 h 298894"/>
                <a:gd name="connsiteX42" fmla="*/ 985559 w 1159900"/>
                <a:gd name="connsiteY42" fmla="*/ 202805 h 298894"/>
                <a:gd name="connsiteX43" fmla="*/ 1006907 w 1159900"/>
                <a:gd name="connsiteY43" fmla="*/ 195689 h 298894"/>
                <a:gd name="connsiteX44" fmla="*/ 1028255 w 1159900"/>
                <a:gd name="connsiteY44" fmla="*/ 177899 h 298894"/>
                <a:gd name="connsiteX45" fmla="*/ 1035371 w 1159900"/>
                <a:gd name="connsiteY45" fmla="*/ 167225 h 298894"/>
                <a:gd name="connsiteX46" fmla="*/ 1056719 w 1159900"/>
                <a:gd name="connsiteY46" fmla="*/ 152993 h 298894"/>
                <a:gd name="connsiteX47" fmla="*/ 1088741 w 1159900"/>
                <a:gd name="connsiteY47" fmla="*/ 131645 h 298894"/>
                <a:gd name="connsiteX48" fmla="*/ 1099415 w 1159900"/>
                <a:gd name="connsiteY48" fmla="*/ 124529 h 298894"/>
                <a:gd name="connsiteX49" fmla="*/ 1117204 w 1159900"/>
                <a:gd name="connsiteY49" fmla="*/ 103181 h 298894"/>
                <a:gd name="connsiteX50" fmla="*/ 1127878 w 1159900"/>
                <a:gd name="connsiteY50" fmla="*/ 92508 h 298894"/>
                <a:gd name="connsiteX51" fmla="*/ 1138552 w 1159900"/>
                <a:gd name="connsiteY51" fmla="*/ 71160 h 298894"/>
                <a:gd name="connsiteX52" fmla="*/ 1149226 w 1159900"/>
                <a:gd name="connsiteY52" fmla="*/ 64044 h 298894"/>
                <a:gd name="connsiteX53" fmla="*/ 1159900 w 1159900"/>
                <a:gd name="connsiteY53" fmla="*/ 53370 h 2988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</a:cxnLst>
              <a:rect l="l" t="t" r="r" b="b"/>
              <a:pathLst>
                <a:path w="1159900" h="298894">
                  <a:moveTo>
                    <a:pt x="0" y="0"/>
                  </a:moveTo>
                  <a:cubicBezTo>
                    <a:pt x="3558" y="1186"/>
                    <a:pt x="7745" y="1215"/>
                    <a:pt x="10674" y="3558"/>
                  </a:cubicBezTo>
                  <a:cubicBezTo>
                    <a:pt x="14013" y="6229"/>
                    <a:pt x="15052" y="10947"/>
                    <a:pt x="17790" y="14232"/>
                  </a:cubicBezTo>
                  <a:cubicBezTo>
                    <a:pt x="28041" y="26533"/>
                    <a:pt x="25983" y="24079"/>
                    <a:pt x="39138" y="28464"/>
                  </a:cubicBezTo>
                  <a:cubicBezTo>
                    <a:pt x="46254" y="35580"/>
                    <a:pt x="54903" y="41439"/>
                    <a:pt x="60485" y="49812"/>
                  </a:cubicBezTo>
                  <a:cubicBezTo>
                    <a:pt x="65229" y="56928"/>
                    <a:pt x="72013" y="63047"/>
                    <a:pt x="74717" y="71160"/>
                  </a:cubicBezTo>
                  <a:cubicBezTo>
                    <a:pt x="75903" y="74718"/>
                    <a:pt x="75623" y="79182"/>
                    <a:pt x="78275" y="81834"/>
                  </a:cubicBezTo>
                  <a:cubicBezTo>
                    <a:pt x="84322" y="87881"/>
                    <a:pt x="92507" y="91322"/>
                    <a:pt x="99623" y="96066"/>
                  </a:cubicBezTo>
                  <a:cubicBezTo>
                    <a:pt x="113415" y="105260"/>
                    <a:pt x="106243" y="101830"/>
                    <a:pt x="120971" y="106739"/>
                  </a:cubicBezTo>
                  <a:cubicBezTo>
                    <a:pt x="151561" y="127132"/>
                    <a:pt x="112858" y="102682"/>
                    <a:pt x="142319" y="117413"/>
                  </a:cubicBezTo>
                  <a:cubicBezTo>
                    <a:pt x="169908" y="131208"/>
                    <a:pt x="136838" y="119144"/>
                    <a:pt x="163667" y="128087"/>
                  </a:cubicBezTo>
                  <a:cubicBezTo>
                    <a:pt x="168411" y="131645"/>
                    <a:pt x="173074" y="135314"/>
                    <a:pt x="177899" y="138761"/>
                  </a:cubicBezTo>
                  <a:cubicBezTo>
                    <a:pt x="181379" y="141246"/>
                    <a:pt x="185288" y="143139"/>
                    <a:pt x="188573" y="145877"/>
                  </a:cubicBezTo>
                  <a:cubicBezTo>
                    <a:pt x="198150" y="153858"/>
                    <a:pt x="198560" y="158618"/>
                    <a:pt x="209920" y="163667"/>
                  </a:cubicBezTo>
                  <a:cubicBezTo>
                    <a:pt x="236104" y="175304"/>
                    <a:pt x="224697" y="165417"/>
                    <a:pt x="245500" y="177899"/>
                  </a:cubicBezTo>
                  <a:cubicBezTo>
                    <a:pt x="252834" y="182299"/>
                    <a:pt x="258735" y="189427"/>
                    <a:pt x="266848" y="192131"/>
                  </a:cubicBezTo>
                  <a:lnTo>
                    <a:pt x="288196" y="199247"/>
                  </a:lnTo>
                  <a:cubicBezTo>
                    <a:pt x="316522" y="218131"/>
                    <a:pt x="301078" y="212270"/>
                    <a:pt x="334450" y="217037"/>
                  </a:cubicBezTo>
                  <a:cubicBezTo>
                    <a:pt x="338008" y="219409"/>
                    <a:pt x="341194" y="222468"/>
                    <a:pt x="345124" y="224153"/>
                  </a:cubicBezTo>
                  <a:cubicBezTo>
                    <a:pt x="349618" y="226079"/>
                    <a:pt x="354672" y="226306"/>
                    <a:pt x="359355" y="227711"/>
                  </a:cubicBezTo>
                  <a:cubicBezTo>
                    <a:pt x="366540" y="229866"/>
                    <a:pt x="373587" y="232455"/>
                    <a:pt x="380703" y="234827"/>
                  </a:cubicBezTo>
                  <a:lnTo>
                    <a:pt x="391377" y="238385"/>
                  </a:lnTo>
                  <a:lnTo>
                    <a:pt x="412725" y="252616"/>
                  </a:lnTo>
                  <a:cubicBezTo>
                    <a:pt x="416283" y="254988"/>
                    <a:pt x="419342" y="258380"/>
                    <a:pt x="423399" y="259732"/>
                  </a:cubicBezTo>
                  <a:lnTo>
                    <a:pt x="444747" y="266848"/>
                  </a:lnTo>
                  <a:cubicBezTo>
                    <a:pt x="448305" y="269220"/>
                    <a:pt x="451596" y="272052"/>
                    <a:pt x="455421" y="273964"/>
                  </a:cubicBezTo>
                  <a:cubicBezTo>
                    <a:pt x="465357" y="278932"/>
                    <a:pt x="481823" y="279769"/>
                    <a:pt x="491001" y="281080"/>
                  </a:cubicBezTo>
                  <a:cubicBezTo>
                    <a:pt x="544440" y="298894"/>
                    <a:pt x="502333" y="287088"/>
                    <a:pt x="611972" y="291754"/>
                  </a:cubicBezTo>
                  <a:cubicBezTo>
                    <a:pt x="634516" y="292713"/>
                    <a:pt x="657039" y="294126"/>
                    <a:pt x="679573" y="295312"/>
                  </a:cubicBezTo>
                  <a:cubicBezTo>
                    <a:pt x="705665" y="294126"/>
                    <a:pt x="731813" y="293837"/>
                    <a:pt x="757849" y="291754"/>
                  </a:cubicBezTo>
                  <a:cubicBezTo>
                    <a:pt x="761588" y="291455"/>
                    <a:pt x="764845" y="288932"/>
                    <a:pt x="768523" y="288196"/>
                  </a:cubicBezTo>
                  <a:cubicBezTo>
                    <a:pt x="776746" y="286551"/>
                    <a:pt x="785127" y="285824"/>
                    <a:pt x="793429" y="284638"/>
                  </a:cubicBezTo>
                  <a:cubicBezTo>
                    <a:pt x="820259" y="275695"/>
                    <a:pt x="787188" y="287759"/>
                    <a:pt x="814776" y="273964"/>
                  </a:cubicBezTo>
                  <a:cubicBezTo>
                    <a:pt x="820463" y="271121"/>
                    <a:pt x="834363" y="268368"/>
                    <a:pt x="839682" y="266848"/>
                  </a:cubicBezTo>
                  <a:cubicBezTo>
                    <a:pt x="843288" y="265818"/>
                    <a:pt x="846750" y="264320"/>
                    <a:pt x="850356" y="263290"/>
                  </a:cubicBezTo>
                  <a:cubicBezTo>
                    <a:pt x="855058" y="261947"/>
                    <a:pt x="859904" y="261137"/>
                    <a:pt x="864588" y="259732"/>
                  </a:cubicBezTo>
                  <a:cubicBezTo>
                    <a:pt x="871773" y="257577"/>
                    <a:pt x="885936" y="252616"/>
                    <a:pt x="885936" y="252616"/>
                  </a:cubicBezTo>
                  <a:cubicBezTo>
                    <a:pt x="919992" y="218563"/>
                    <a:pt x="876385" y="258984"/>
                    <a:pt x="907284" y="238385"/>
                  </a:cubicBezTo>
                  <a:cubicBezTo>
                    <a:pt x="911471" y="235594"/>
                    <a:pt x="913771" y="230502"/>
                    <a:pt x="917958" y="227711"/>
                  </a:cubicBezTo>
                  <a:cubicBezTo>
                    <a:pt x="921219" y="225537"/>
                    <a:pt x="940707" y="221242"/>
                    <a:pt x="942864" y="220595"/>
                  </a:cubicBezTo>
                  <a:cubicBezTo>
                    <a:pt x="950048" y="218440"/>
                    <a:pt x="957095" y="215851"/>
                    <a:pt x="964211" y="213479"/>
                  </a:cubicBezTo>
                  <a:lnTo>
                    <a:pt x="974885" y="209921"/>
                  </a:lnTo>
                  <a:cubicBezTo>
                    <a:pt x="978443" y="207549"/>
                    <a:pt x="981651" y="204542"/>
                    <a:pt x="985559" y="202805"/>
                  </a:cubicBezTo>
                  <a:cubicBezTo>
                    <a:pt x="992413" y="199759"/>
                    <a:pt x="1006907" y="195689"/>
                    <a:pt x="1006907" y="195689"/>
                  </a:cubicBezTo>
                  <a:cubicBezTo>
                    <a:pt x="1017402" y="188692"/>
                    <a:pt x="1019694" y="188172"/>
                    <a:pt x="1028255" y="177899"/>
                  </a:cubicBezTo>
                  <a:cubicBezTo>
                    <a:pt x="1030993" y="174614"/>
                    <a:pt x="1032153" y="170041"/>
                    <a:pt x="1035371" y="167225"/>
                  </a:cubicBezTo>
                  <a:cubicBezTo>
                    <a:pt x="1041807" y="161593"/>
                    <a:pt x="1049603" y="157737"/>
                    <a:pt x="1056719" y="152993"/>
                  </a:cubicBezTo>
                  <a:lnTo>
                    <a:pt x="1088741" y="131645"/>
                  </a:lnTo>
                  <a:cubicBezTo>
                    <a:pt x="1092299" y="129273"/>
                    <a:pt x="1096391" y="127553"/>
                    <a:pt x="1099415" y="124529"/>
                  </a:cubicBezTo>
                  <a:cubicBezTo>
                    <a:pt x="1130608" y="93336"/>
                    <a:pt x="1092430" y="132910"/>
                    <a:pt x="1117204" y="103181"/>
                  </a:cubicBezTo>
                  <a:cubicBezTo>
                    <a:pt x="1120425" y="99316"/>
                    <a:pt x="1124320" y="96066"/>
                    <a:pt x="1127878" y="92508"/>
                  </a:cubicBezTo>
                  <a:cubicBezTo>
                    <a:pt x="1130772" y="83827"/>
                    <a:pt x="1131655" y="78057"/>
                    <a:pt x="1138552" y="71160"/>
                  </a:cubicBezTo>
                  <a:cubicBezTo>
                    <a:pt x="1141576" y="68136"/>
                    <a:pt x="1145668" y="66416"/>
                    <a:pt x="1149226" y="64044"/>
                  </a:cubicBezTo>
                  <a:cubicBezTo>
                    <a:pt x="1157000" y="52383"/>
                    <a:pt x="1152066" y="53370"/>
                    <a:pt x="1159900" y="53370"/>
                  </a:cubicBezTo>
                </a:path>
              </a:pathLst>
            </a:custGeom>
            <a:ln w="6350"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" name="Right Brace 34"/>
            <p:cNvSpPr/>
            <p:nvPr/>
          </p:nvSpPr>
          <p:spPr>
            <a:xfrm>
              <a:off x="6581906" y="1035984"/>
              <a:ext cx="45719" cy="313726"/>
            </a:xfrm>
            <a:prstGeom prst="rightBrace">
              <a:avLst>
                <a:gd name="adj1" fmla="val 40476"/>
                <a:gd name="adj2" fmla="val 50000"/>
              </a:avLst>
            </a:prstGeom>
            <a:noFill/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" name="Right Brace 35"/>
            <p:cNvSpPr/>
            <p:nvPr/>
          </p:nvSpPr>
          <p:spPr>
            <a:xfrm>
              <a:off x="6581906" y="1360015"/>
              <a:ext cx="45719" cy="497384"/>
            </a:xfrm>
            <a:prstGeom prst="rightBrace">
              <a:avLst>
                <a:gd name="adj1" fmla="val 40476"/>
                <a:gd name="adj2" fmla="val 50000"/>
              </a:avLst>
            </a:prstGeom>
            <a:noFill/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6548794" y="732434"/>
              <a:ext cx="381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altLang="zh-HK" sz="1000" b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PZ</a:t>
              </a:r>
              <a:endParaRPr lang="zh-HK" alt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6545191" y="1080544"/>
              <a:ext cx="4415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altLang="zh-HK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PHZ</a:t>
              </a:r>
              <a:endParaRPr lang="zh-HK" alt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547857" y="1467750"/>
              <a:ext cx="378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altLang="zh-HK" sz="10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HZ</a:t>
              </a:r>
              <a:endParaRPr lang="zh-HK" alt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Text Box 1300"/>
            <p:cNvSpPr txBox="1">
              <a:spLocks noChangeArrowheads="1"/>
            </p:cNvSpPr>
            <p:nvPr/>
          </p:nvSpPr>
          <p:spPr bwMode="auto">
            <a:xfrm>
              <a:off x="6294438" y="2535774"/>
              <a:ext cx="682624" cy="2785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lIns="92930" tIns="46465" rIns="92930" bIns="46465">
              <a:spAutoFit/>
            </a:bodyPr>
            <a:lstStyle/>
            <a:p>
              <a:pPr algn="ctr" defTabSz="2927049">
                <a:spcBef>
                  <a:spcPct val="50000"/>
                </a:spcBef>
                <a:defRPr/>
              </a:pPr>
              <a:r>
                <a:rPr lang="en-US" sz="1200" b="1" i="1" kern="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Sox9</a:t>
              </a:r>
              <a:endParaRPr lang="en-US" sz="1200" b="1" i="1" kern="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42" name="Text Box 1300"/>
          <p:cNvSpPr txBox="1">
            <a:spLocks noChangeArrowheads="1"/>
          </p:cNvSpPr>
          <p:nvPr/>
        </p:nvSpPr>
        <p:spPr bwMode="auto">
          <a:xfrm>
            <a:off x="414989" y="618171"/>
            <a:ext cx="256420" cy="283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  <a:defRPr/>
            </a:pPr>
            <a:r>
              <a:rPr lang="en-US" sz="1200" b="1" kern="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243" name="Text Box 1300"/>
          <p:cNvSpPr txBox="1">
            <a:spLocks noChangeArrowheads="1"/>
          </p:cNvSpPr>
          <p:nvPr/>
        </p:nvSpPr>
        <p:spPr bwMode="auto">
          <a:xfrm>
            <a:off x="3672642" y="618169"/>
            <a:ext cx="256420" cy="283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  <a:defRPr/>
            </a:pPr>
            <a:r>
              <a:rPr lang="en-US" sz="1200" b="1" kern="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43" name="Text Box 1300"/>
          <p:cNvSpPr txBox="1">
            <a:spLocks noChangeArrowheads="1"/>
          </p:cNvSpPr>
          <p:nvPr/>
        </p:nvSpPr>
        <p:spPr bwMode="auto">
          <a:xfrm>
            <a:off x="414989" y="2819400"/>
            <a:ext cx="256420" cy="283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  <a:defRPr/>
            </a:pPr>
            <a:r>
              <a:rPr lang="en-US" sz="12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</a:t>
            </a:r>
            <a:endParaRPr lang="en-US" sz="12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 Box 1300"/>
          <p:cNvSpPr txBox="1">
            <a:spLocks noChangeArrowheads="1"/>
          </p:cNvSpPr>
          <p:nvPr/>
        </p:nvSpPr>
        <p:spPr bwMode="auto">
          <a:xfrm>
            <a:off x="3712982" y="2819400"/>
            <a:ext cx="256420" cy="283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  <a:defRPr/>
            </a:pPr>
            <a:r>
              <a:rPr lang="en-US" sz="12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</a:t>
            </a:r>
            <a:endParaRPr lang="en-US" sz="12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 Box 1300"/>
          <p:cNvSpPr txBox="1">
            <a:spLocks noChangeArrowheads="1"/>
          </p:cNvSpPr>
          <p:nvPr/>
        </p:nvSpPr>
        <p:spPr bwMode="auto">
          <a:xfrm>
            <a:off x="414989" y="5316767"/>
            <a:ext cx="256420" cy="283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  <a:defRPr/>
            </a:pPr>
            <a:r>
              <a:rPr lang="en-US" sz="12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E</a:t>
            </a:r>
            <a:endParaRPr lang="en-US" sz="12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168753" y="3585661"/>
            <a:ext cx="948153" cy="345167"/>
          </a:xfrm>
          <a:prstGeom prst="rect">
            <a:avLst/>
          </a:prstGeom>
          <a:noFill/>
        </p:spPr>
        <p:txBody>
          <a:bodyPr wrap="square" lIns="92930" tIns="46465" rIns="92930" bIns="46465" rtlCol="0">
            <a:spAutoFit/>
          </a:bodyPr>
          <a:lstStyle/>
          <a:p>
            <a:pPr algn="ctr">
              <a:defRPr/>
            </a:pPr>
            <a:r>
              <a:rPr lang="en-US" sz="12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OX9 </a:t>
            </a:r>
            <a:endParaRPr lang="en-US" sz="12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6200000">
            <a:off x="71881" y="4436437"/>
            <a:ext cx="1088974" cy="292244"/>
          </a:xfrm>
          <a:prstGeom prst="rect">
            <a:avLst/>
          </a:prstGeom>
          <a:noFill/>
        </p:spPr>
        <p:txBody>
          <a:bodyPr wrap="square" lIns="92930" tIns="46465" rIns="92930" bIns="46465" rtlCol="0">
            <a:spAutoFit/>
          </a:bodyPr>
          <a:lstStyle/>
          <a:p>
            <a:pPr algn="ctr">
              <a:defRPr/>
            </a:pPr>
            <a:r>
              <a:rPr lang="el-GR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β </a:t>
            </a:r>
            <a:r>
              <a:rPr lang="en-US" sz="12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-Actin</a:t>
            </a:r>
            <a:endParaRPr lang="en-US" sz="12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 Box 1300"/>
          <p:cNvSpPr txBox="1">
            <a:spLocks noChangeArrowheads="1"/>
          </p:cNvSpPr>
          <p:nvPr/>
        </p:nvSpPr>
        <p:spPr bwMode="auto">
          <a:xfrm>
            <a:off x="743017" y="3200400"/>
            <a:ext cx="781177" cy="3616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</a:pPr>
            <a:r>
              <a:rPr lang="en-US" altLang="zh-HK" sz="1200" b="1" dirty="0" smtClean="0">
                <a:latin typeface="Arial" pitchFamily="34" charset="0"/>
                <a:cs typeface="Arial" pitchFamily="34" charset="0"/>
              </a:rPr>
              <a:t>Mock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 Box 1300"/>
          <p:cNvSpPr txBox="1">
            <a:spLocks noChangeArrowheads="1"/>
          </p:cNvSpPr>
          <p:nvPr/>
        </p:nvSpPr>
        <p:spPr bwMode="auto">
          <a:xfrm>
            <a:off x="1472874" y="3200400"/>
            <a:ext cx="781177" cy="3616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</a:pPr>
            <a:r>
              <a:rPr lang="en-US" altLang="zh-HK" sz="1200" b="1" dirty="0" smtClean="0">
                <a:latin typeface="Arial" pitchFamily="34" charset="0"/>
                <a:cs typeface="Arial" pitchFamily="34" charset="0"/>
              </a:rPr>
              <a:t>0.1</a:t>
            </a:r>
            <a:r>
              <a:rPr lang="el-GR" altLang="zh-HK" sz="12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zh-HK" sz="1200" b="1" dirty="0">
                <a:latin typeface="Arial" pitchFamily="34" charset="0"/>
                <a:cs typeface="Arial" pitchFamily="34" charset="0"/>
              </a:rPr>
              <a:t>g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 Box 1300"/>
          <p:cNvSpPr txBox="1">
            <a:spLocks noChangeArrowheads="1"/>
          </p:cNvSpPr>
          <p:nvPr/>
        </p:nvSpPr>
        <p:spPr bwMode="auto">
          <a:xfrm>
            <a:off x="2133952" y="3200400"/>
            <a:ext cx="781177" cy="3616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</a:pPr>
            <a:r>
              <a:rPr lang="en-US" altLang="zh-HK" sz="1200" b="1" dirty="0" smtClean="0">
                <a:latin typeface="Arial" pitchFamily="34" charset="0"/>
                <a:cs typeface="Arial" pitchFamily="34" charset="0"/>
              </a:rPr>
              <a:t>0.5</a:t>
            </a:r>
            <a:r>
              <a:rPr lang="el-GR" altLang="zh-HK" sz="12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zh-HK" sz="1200" b="1" dirty="0">
                <a:latin typeface="Arial" pitchFamily="34" charset="0"/>
                <a:cs typeface="Arial" pitchFamily="34" charset="0"/>
              </a:rPr>
              <a:t>g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 Box 1300"/>
          <p:cNvSpPr txBox="1">
            <a:spLocks noChangeArrowheads="1"/>
          </p:cNvSpPr>
          <p:nvPr/>
        </p:nvSpPr>
        <p:spPr bwMode="auto">
          <a:xfrm>
            <a:off x="2889469" y="3200400"/>
            <a:ext cx="781177" cy="3616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</a:pPr>
            <a:r>
              <a:rPr lang="en-US" altLang="zh-HK" sz="1200" b="1" dirty="0" smtClean="0">
                <a:latin typeface="Arial" pitchFamily="34" charset="0"/>
                <a:cs typeface="Arial" pitchFamily="34" charset="0"/>
              </a:rPr>
              <a:t>1</a:t>
            </a:r>
            <a:r>
              <a:rPr lang="el-GR" altLang="zh-HK" sz="12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zh-HK" sz="1200" b="1" dirty="0">
                <a:latin typeface="Arial" pitchFamily="34" charset="0"/>
                <a:cs typeface="Arial" pitchFamily="34" charset="0"/>
              </a:rPr>
              <a:t>g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5" name="Chart 2"/>
          <p:cNvGraphicFramePr/>
          <p:nvPr>
            <p:extLst>
              <p:ext uri="{D42A27DB-BD31-4B8C-83A1-F6EECF244321}">
                <p14:modId xmlns:p14="http://schemas.microsoft.com/office/powerpoint/2010/main" val="2633820082"/>
              </p:ext>
            </p:extLst>
          </p:nvPr>
        </p:nvGraphicFramePr>
        <p:xfrm>
          <a:off x="3776663" y="2961213"/>
          <a:ext cx="3124199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57" name="TextBox 56"/>
          <p:cNvSpPr txBox="1"/>
          <p:nvPr/>
        </p:nvSpPr>
        <p:spPr>
          <a:xfrm rot="16200000">
            <a:off x="2889319" y="6607658"/>
            <a:ext cx="2006583" cy="247726"/>
          </a:xfrm>
          <a:prstGeom prst="rect">
            <a:avLst/>
          </a:prstGeom>
          <a:noFill/>
        </p:spPr>
        <p:txBody>
          <a:bodyPr wrap="square" lIns="92930" tIns="46465" rIns="92930" bIns="46465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Ptch1 Luciferase Activities</a:t>
            </a:r>
          </a:p>
        </p:txBody>
      </p:sp>
      <p:graphicFrame>
        <p:nvGraphicFramePr>
          <p:cNvPr id="62" name="Chart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9636193"/>
              </p:ext>
            </p:extLst>
          </p:nvPr>
        </p:nvGraphicFramePr>
        <p:xfrm>
          <a:off x="4094922" y="5597714"/>
          <a:ext cx="2831271" cy="25233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63" name="Text Box 1300"/>
          <p:cNvSpPr txBox="1">
            <a:spLocks noChangeArrowheads="1"/>
          </p:cNvSpPr>
          <p:nvPr/>
        </p:nvSpPr>
        <p:spPr bwMode="auto">
          <a:xfrm>
            <a:off x="3716364" y="5316767"/>
            <a:ext cx="256420" cy="283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  <a:defRPr/>
            </a:pPr>
            <a:r>
              <a:rPr lang="en-US" sz="1200" b="1" kern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</a:t>
            </a:r>
            <a:endParaRPr lang="en-US" sz="1200" b="1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25897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203</TotalTime>
  <Words>40</Words>
  <Application>Microsoft Office PowerPoint</Application>
  <PresentationFormat>Custom</PresentationFormat>
  <Paragraphs>2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K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iochemistry</dc:creator>
  <cp:lastModifiedBy>Tommy</cp:lastModifiedBy>
  <cp:revision>1122</cp:revision>
  <cp:lastPrinted>2014-04-16T04:20:03Z</cp:lastPrinted>
  <dcterms:created xsi:type="dcterms:W3CDTF">2013-02-18T08:57:14Z</dcterms:created>
  <dcterms:modified xsi:type="dcterms:W3CDTF">2018-04-08T08:54:34Z</dcterms:modified>
</cp:coreProperties>
</file>